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0004"/>
    <a:srgbClr val="4543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>
        <p:scale>
          <a:sx n="125" d="100"/>
          <a:sy n="125" d="100"/>
        </p:scale>
        <p:origin x="-1066" y="-86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4FFD6-71BA-4AF0-A400-281516020C13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A1C78-C6F1-4AB9-876F-E67D4E097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2822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4FFD6-71BA-4AF0-A400-281516020C13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A1C78-C6F1-4AB9-876F-E67D4E097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164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4FFD6-71BA-4AF0-A400-281516020C13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A1C78-C6F1-4AB9-876F-E67D4E097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760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4FFD6-71BA-4AF0-A400-281516020C13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A1C78-C6F1-4AB9-876F-E67D4E097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606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4FFD6-71BA-4AF0-A400-281516020C13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A1C78-C6F1-4AB9-876F-E67D4E097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7183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4FFD6-71BA-4AF0-A400-281516020C13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A1C78-C6F1-4AB9-876F-E67D4E097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670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4FFD6-71BA-4AF0-A400-281516020C13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A1C78-C6F1-4AB9-876F-E67D4E097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418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4FFD6-71BA-4AF0-A400-281516020C13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A1C78-C6F1-4AB9-876F-E67D4E097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611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4FFD6-71BA-4AF0-A400-281516020C13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A1C78-C6F1-4AB9-876F-E67D4E097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417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4FFD6-71BA-4AF0-A400-281516020C13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A1C78-C6F1-4AB9-876F-E67D4E097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338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94FFD6-71BA-4AF0-A400-281516020C13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A1C78-C6F1-4AB9-876F-E67D4E097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6577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94FFD6-71BA-4AF0-A400-281516020C13}" type="datetimeFigureOut">
              <a:rPr lang="en-US" smtClean="0"/>
              <a:t>8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A1C78-C6F1-4AB9-876F-E67D4E097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387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EBDE6A5-38BB-004F-9288-EF30CBDB685F}"/>
              </a:ext>
            </a:extLst>
          </p:cNvPr>
          <p:cNvGrpSpPr/>
          <p:nvPr/>
        </p:nvGrpSpPr>
        <p:grpSpPr>
          <a:xfrm>
            <a:off x="2411201" y="4831430"/>
            <a:ext cx="6257271" cy="119041"/>
            <a:chOff x="1201364" y="4911346"/>
            <a:chExt cx="6257271" cy="119041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311017C-DDA3-8A41-8991-B9EDA6500B9E}"/>
                </a:ext>
              </a:extLst>
            </p:cNvPr>
            <p:cNvSpPr txBox="1"/>
            <p:nvPr/>
          </p:nvSpPr>
          <p:spPr>
            <a:xfrm rot="18900000">
              <a:off x="1201364" y="4911346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Baseline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4021592-723A-474C-963B-CE8469380BF7}"/>
                </a:ext>
              </a:extLst>
            </p:cNvPr>
            <p:cNvSpPr txBox="1"/>
            <p:nvPr/>
          </p:nvSpPr>
          <p:spPr>
            <a:xfrm rot="18900000">
              <a:off x="1335867" y="4911347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2D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2E2598B-9612-5348-AA60-DFA90A5C0B8D}"/>
                </a:ext>
              </a:extLst>
            </p:cNvPr>
            <p:cNvSpPr txBox="1"/>
            <p:nvPr/>
          </p:nvSpPr>
          <p:spPr>
            <a:xfrm rot="18900000">
              <a:off x="1470370" y="4911349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3D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F152EFC-6A75-1C44-8BC5-6158B707C1F9}"/>
                </a:ext>
              </a:extLst>
            </p:cNvPr>
            <p:cNvSpPr txBox="1"/>
            <p:nvPr/>
          </p:nvSpPr>
          <p:spPr>
            <a:xfrm rot="18900000">
              <a:off x="1604873" y="4911347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4D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487DE0F-DEDD-5243-83ED-9257849E1DF9}"/>
                </a:ext>
              </a:extLst>
            </p:cNvPr>
            <p:cNvSpPr txBox="1"/>
            <p:nvPr/>
          </p:nvSpPr>
          <p:spPr>
            <a:xfrm rot="18900000">
              <a:off x="1739376" y="4911349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5D1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49FAC97-D461-3142-A3AB-95CE1A47300E}"/>
                </a:ext>
              </a:extLst>
            </p:cNvPr>
            <p:cNvSpPr txBox="1"/>
            <p:nvPr/>
          </p:nvSpPr>
          <p:spPr>
            <a:xfrm rot="18900000">
              <a:off x="1873879" y="4911347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6D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69143BC-D941-3541-A3C7-7F01F97C954A}"/>
                </a:ext>
              </a:extLst>
            </p:cNvPr>
            <p:cNvSpPr txBox="1"/>
            <p:nvPr/>
          </p:nvSpPr>
          <p:spPr>
            <a:xfrm rot="18900000">
              <a:off x="2008382" y="4911349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7D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F723E6D-F632-584D-A6C9-5BB2D31497E3}"/>
                </a:ext>
              </a:extLst>
            </p:cNvPr>
            <p:cNvSpPr txBox="1"/>
            <p:nvPr/>
          </p:nvSpPr>
          <p:spPr>
            <a:xfrm rot="18900000">
              <a:off x="2142885" y="4911348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8D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695D60B-972D-4D4F-86F6-A8A9D4EAB42E}"/>
                </a:ext>
              </a:extLst>
            </p:cNvPr>
            <p:cNvSpPr txBox="1"/>
            <p:nvPr/>
          </p:nvSpPr>
          <p:spPr>
            <a:xfrm rot="18900000">
              <a:off x="2277388" y="4911350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9D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87E826B-3ED6-7349-A94E-47B3DDA1C38B}"/>
                </a:ext>
              </a:extLst>
            </p:cNvPr>
            <p:cNvSpPr txBox="1"/>
            <p:nvPr/>
          </p:nvSpPr>
          <p:spPr>
            <a:xfrm rot="18900000">
              <a:off x="2411891" y="4911351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10D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3412D20-F3F8-8647-8787-509E2ABE1AB8}"/>
                </a:ext>
              </a:extLst>
            </p:cNvPr>
            <p:cNvSpPr txBox="1"/>
            <p:nvPr/>
          </p:nvSpPr>
          <p:spPr>
            <a:xfrm rot="18900000">
              <a:off x="2546394" y="4911352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11D1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CBF940B-23F5-0442-B2F0-F10717241A47}"/>
                </a:ext>
              </a:extLst>
            </p:cNvPr>
            <p:cNvSpPr txBox="1"/>
            <p:nvPr/>
          </p:nvSpPr>
          <p:spPr>
            <a:xfrm rot="18900000">
              <a:off x="2680897" y="4911347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12D1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5B58F80-B369-E548-A556-83EBF8018993}"/>
                </a:ext>
              </a:extLst>
            </p:cNvPr>
            <p:cNvSpPr txBox="1"/>
            <p:nvPr/>
          </p:nvSpPr>
          <p:spPr>
            <a:xfrm rot="18900000">
              <a:off x="2815400" y="4911349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13D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66BE8980-3445-0449-9F23-5B0AF6FF6867}"/>
                </a:ext>
              </a:extLst>
            </p:cNvPr>
            <p:cNvSpPr txBox="1"/>
            <p:nvPr/>
          </p:nvSpPr>
          <p:spPr>
            <a:xfrm rot="18900000">
              <a:off x="2949903" y="4911347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14D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DB1677D-FFBD-E14E-8AA3-BC2860DED0AB}"/>
                </a:ext>
              </a:extLst>
            </p:cNvPr>
            <p:cNvSpPr txBox="1"/>
            <p:nvPr/>
          </p:nvSpPr>
          <p:spPr>
            <a:xfrm rot="18900000">
              <a:off x="3084406" y="4911349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15D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0FBD72D-27B4-934D-92CE-143DC042E7C3}"/>
                </a:ext>
              </a:extLst>
            </p:cNvPr>
            <p:cNvSpPr txBox="1"/>
            <p:nvPr/>
          </p:nvSpPr>
          <p:spPr>
            <a:xfrm rot="18900000">
              <a:off x="3218909" y="4911347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16D1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9991259-1B5E-3846-928D-355B395BF5C0}"/>
                </a:ext>
              </a:extLst>
            </p:cNvPr>
            <p:cNvSpPr txBox="1"/>
            <p:nvPr/>
          </p:nvSpPr>
          <p:spPr>
            <a:xfrm rot="18900000">
              <a:off x="3353412" y="4911349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17D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916E354-A79D-6042-A140-CD2B441684C6}"/>
                </a:ext>
              </a:extLst>
            </p:cNvPr>
            <p:cNvSpPr txBox="1"/>
            <p:nvPr/>
          </p:nvSpPr>
          <p:spPr>
            <a:xfrm rot="18900000">
              <a:off x="3487915" y="4911348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18D1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8D686C9F-962E-ED40-8804-978B2BB0C536}"/>
                </a:ext>
              </a:extLst>
            </p:cNvPr>
            <p:cNvSpPr txBox="1"/>
            <p:nvPr/>
          </p:nvSpPr>
          <p:spPr>
            <a:xfrm rot="18900000">
              <a:off x="3622418" y="4911350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19D1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5DB58F4D-7E73-0045-9707-F4A251149E05}"/>
                </a:ext>
              </a:extLst>
            </p:cNvPr>
            <p:cNvSpPr txBox="1"/>
            <p:nvPr/>
          </p:nvSpPr>
          <p:spPr>
            <a:xfrm rot="18900000">
              <a:off x="3756921" y="4911351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20D1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4FC488F-21BA-8E4C-A209-96E53AABB4E7}"/>
                </a:ext>
              </a:extLst>
            </p:cNvPr>
            <p:cNvSpPr txBox="1"/>
            <p:nvPr/>
          </p:nvSpPr>
          <p:spPr>
            <a:xfrm rot="18900000">
              <a:off x="3891424" y="4911352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21D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AF619C8-A3A2-5145-9C6A-4F07E1AADFAA}"/>
                </a:ext>
              </a:extLst>
            </p:cNvPr>
            <p:cNvSpPr txBox="1"/>
            <p:nvPr/>
          </p:nvSpPr>
          <p:spPr>
            <a:xfrm rot="18900000">
              <a:off x="4025927" y="4911348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22D1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E769327-7738-FC40-A57A-40943D235E6B}"/>
                </a:ext>
              </a:extLst>
            </p:cNvPr>
            <p:cNvSpPr txBox="1"/>
            <p:nvPr/>
          </p:nvSpPr>
          <p:spPr>
            <a:xfrm rot="18900000">
              <a:off x="4160430" y="4911350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23D1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4708AEB-6E80-4E46-A95F-831B8E0A5D2D}"/>
                </a:ext>
              </a:extLst>
            </p:cNvPr>
            <p:cNvSpPr txBox="1"/>
            <p:nvPr/>
          </p:nvSpPr>
          <p:spPr>
            <a:xfrm rot="18900000">
              <a:off x="4294933" y="4911348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24D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B8E20EC-385C-3D4B-AEF0-778DC31E2F20}"/>
                </a:ext>
              </a:extLst>
            </p:cNvPr>
            <p:cNvSpPr txBox="1"/>
            <p:nvPr/>
          </p:nvSpPr>
          <p:spPr>
            <a:xfrm rot="18900000">
              <a:off x="4429436" y="4911350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25D1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489666A-FF26-5446-8A3A-C9207765FA6C}"/>
                </a:ext>
              </a:extLst>
            </p:cNvPr>
            <p:cNvSpPr txBox="1"/>
            <p:nvPr/>
          </p:nvSpPr>
          <p:spPr>
            <a:xfrm rot="18900000">
              <a:off x="4563939" y="4911348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26D1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0C12D06-ED05-254B-85B5-D31B3597EA49}"/>
                </a:ext>
              </a:extLst>
            </p:cNvPr>
            <p:cNvSpPr txBox="1"/>
            <p:nvPr/>
          </p:nvSpPr>
          <p:spPr>
            <a:xfrm rot="18900000">
              <a:off x="4698442" y="4911350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27D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7838F75-3BBA-3649-9718-8B7663C119CB}"/>
                </a:ext>
              </a:extLst>
            </p:cNvPr>
            <p:cNvSpPr txBox="1"/>
            <p:nvPr/>
          </p:nvSpPr>
          <p:spPr>
            <a:xfrm rot="18900000">
              <a:off x="4832945" y="4911349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28D1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9731497B-EE31-AB45-86BF-D51F97A941FB}"/>
                </a:ext>
              </a:extLst>
            </p:cNvPr>
            <p:cNvSpPr txBox="1"/>
            <p:nvPr/>
          </p:nvSpPr>
          <p:spPr>
            <a:xfrm rot="18900000">
              <a:off x="4967448" y="4911351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29D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EB57AC3-DEC0-A04E-BCF2-901D137890AE}"/>
                </a:ext>
              </a:extLst>
            </p:cNvPr>
            <p:cNvSpPr txBox="1"/>
            <p:nvPr/>
          </p:nvSpPr>
          <p:spPr>
            <a:xfrm rot="18900000">
              <a:off x="5101951" y="4911352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30D1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02ECF74-1739-CC45-B6EB-8DE95661EBE1}"/>
                </a:ext>
              </a:extLst>
            </p:cNvPr>
            <p:cNvSpPr txBox="1"/>
            <p:nvPr/>
          </p:nvSpPr>
          <p:spPr>
            <a:xfrm rot="18900000">
              <a:off x="5236454" y="4911353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31D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13103E91-C041-3940-ACA0-BFD9CBF96A79}"/>
                </a:ext>
              </a:extLst>
            </p:cNvPr>
            <p:cNvSpPr txBox="1"/>
            <p:nvPr/>
          </p:nvSpPr>
          <p:spPr>
            <a:xfrm rot="18900000">
              <a:off x="5370957" y="4911348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32D1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4C95EAD-2C59-3E48-9648-06580BFC1049}"/>
                </a:ext>
              </a:extLst>
            </p:cNvPr>
            <p:cNvSpPr txBox="1"/>
            <p:nvPr/>
          </p:nvSpPr>
          <p:spPr>
            <a:xfrm rot="18900000">
              <a:off x="5505460" y="4911350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33D1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B4DC805-D5C8-FC42-AA7E-0284CCC64490}"/>
                </a:ext>
              </a:extLst>
            </p:cNvPr>
            <p:cNvSpPr txBox="1"/>
            <p:nvPr/>
          </p:nvSpPr>
          <p:spPr>
            <a:xfrm rot="18900000">
              <a:off x="5639963" y="4911348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34D1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F026317-EED5-934F-943F-C4E64896C0A1}"/>
                </a:ext>
              </a:extLst>
            </p:cNvPr>
            <p:cNvSpPr txBox="1"/>
            <p:nvPr/>
          </p:nvSpPr>
          <p:spPr>
            <a:xfrm rot="18900000">
              <a:off x="5774466" y="4911350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35D1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E040E9BF-5C24-2141-9652-332C1234FC38}"/>
                </a:ext>
              </a:extLst>
            </p:cNvPr>
            <p:cNvSpPr txBox="1"/>
            <p:nvPr/>
          </p:nvSpPr>
          <p:spPr>
            <a:xfrm rot="18900000">
              <a:off x="5908969" y="4911348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36D1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70BF9BF-D589-9F47-B261-E198FE3162C8}"/>
                </a:ext>
              </a:extLst>
            </p:cNvPr>
            <p:cNvSpPr txBox="1"/>
            <p:nvPr/>
          </p:nvSpPr>
          <p:spPr>
            <a:xfrm rot="18900000">
              <a:off x="6043472" y="4911350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37D1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9216890-1675-E343-B450-15D2F1491CEC}"/>
                </a:ext>
              </a:extLst>
            </p:cNvPr>
            <p:cNvSpPr txBox="1"/>
            <p:nvPr/>
          </p:nvSpPr>
          <p:spPr>
            <a:xfrm rot="18900000">
              <a:off x="6177975" y="4911349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38D1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DA4FAC4-64ED-1E4C-90D9-B7F80ADC61B9}"/>
                </a:ext>
              </a:extLst>
            </p:cNvPr>
            <p:cNvSpPr txBox="1"/>
            <p:nvPr/>
          </p:nvSpPr>
          <p:spPr>
            <a:xfrm rot="18900000">
              <a:off x="6312478" y="4911351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39D1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E7CED02-D664-6D42-9637-87617BF45DAE}"/>
                </a:ext>
              </a:extLst>
            </p:cNvPr>
            <p:cNvSpPr txBox="1"/>
            <p:nvPr/>
          </p:nvSpPr>
          <p:spPr>
            <a:xfrm rot="18900000">
              <a:off x="6446981" y="4911352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40D1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E713438F-856A-0748-9252-729D3B5A0612}"/>
                </a:ext>
              </a:extLst>
            </p:cNvPr>
            <p:cNvSpPr txBox="1"/>
            <p:nvPr/>
          </p:nvSpPr>
          <p:spPr>
            <a:xfrm rot="18900000">
              <a:off x="6581484" y="4911353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C41D1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EC8610C7-7368-BC4C-9B67-3C0E9FCE07B8}"/>
                </a:ext>
              </a:extLst>
            </p:cNvPr>
            <p:cNvSpPr txBox="1"/>
            <p:nvPr/>
          </p:nvSpPr>
          <p:spPr>
            <a:xfrm rot="18900000">
              <a:off x="6715987" y="4911351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EOT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BC6CD09F-4946-E643-B6EE-39D0480283C6}"/>
                </a:ext>
              </a:extLst>
            </p:cNvPr>
            <p:cNvSpPr txBox="1"/>
            <p:nvPr/>
          </p:nvSpPr>
          <p:spPr>
            <a:xfrm rot="18900000">
              <a:off x="6850490" y="4911352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EFS 1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7C1C02D6-CACB-0B47-A775-580CBD458D2C}"/>
                </a:ext>
              </a:extLst>
            </p:cNvPr>
            <p:cNvSpPr txBox="1"/>
            <p:nvPr/>
          </p:nvSpPr>
          <p:spPr>
            <a:xfrm rot="18900000">
              <a:off x="6985002" y="4911353"/>
              <a:ext cx="473633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700" dirty="0">
                  <a:latin typeface="Arial" panose="020B0604020202020204" pitchFamily="34" charset="0"/>
                  <a:cs typeface="Arial" panose="020B0604020202020204" pitchFamily="34" charset="0"/>
                </a:rPr>
                <a:t>EFS 5</a:t>
              </a:r>
            </a:p>
          </p:txBody>
        </p: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DB0C58DC-2A62-9D48-B7E4-E84D9A79E796}"/>
              </a:ext>
            </a:extLst>
          </p:cNvPr>
          <p:cNvGrpSpPr/>
          <p:nvPr/>
        </p:nvGrpSpPr>
        <p:grpSpPr>
          <a:xfrm>
            <a:off x="2743436" y="1846761"/>
            <a:ext cx="5889600" cy="2750400"/>
            <a:chOff x="2453843" y="2992997"/>
            <a:chExt cx="4384732" cy="2191747"/>
          </a:xfrm>
        </p:grpSpPr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5E6D3158-CC4E-E948-BC79-8EBE952A329C}"/>
                </a:ext>
              </a:extLst>
            </p:cNvPr>
            <p:cNvCxnSpPr>
              <a:cxnSpLocks/>
            </p:cNvCxnSpPr>
            <p:nvPr/>
          </p:nvCxnSpPr>
          <p:spPr>
            <a:xfrm>
              <a:off x="2456122" y="2992997"/>
              <a:ext cx="1" cy="2191747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3BBDF319-D524-924B-A6B6-978A03FE7BB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53843" y="5183372"/>
              <a:ext cx="438473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2728874A-6FD8-204E-AA2B-FC284995C12B}"/>
              </a:ext>
            </a:extLst>
          </p:cNvPr>
          <p:cNvGrpSpPr/>
          <p:nvPr/>
        </p:nvGrpSpPr>
        <p:grpSpPr>
          <a:xfrm>
            <a:off x="2693605" y="1850503"/>
            <a:ext cx="52892" cy="2744939"/>
            <a:chOff x="1702843" y="1930419"/>
            <a:chExt cx="52892" cy="2744939"/>
          </a:xfrm>
        </p:grpSpPr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5D73E74D-848D-F64E-AB4E-575431A691A5}"/>
                </a:ext>
              </a:extLst>
            </p:cNvPr>
            <p:cNvCxnSpPr>
              <a:cxnSpLocks/>
            </p:cNvCxnSpPr>
            <p:nvPr/>
          </p:nvCxnSpPr>
          <p:spPr>
            <a:xfrm>
              <a:off x="1702843" y="4675358"/>
              <a:ext cx="5289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FF042B48-B3EA-E948-BC6D-0E238C14C97D}"/>
                </a:ext>
              </a:extLst>
            </p:cNvPr>
            <p:cNvCxnSpPr>
              <a:cxnSpLocks/>
            </p:cNvCxnSpPr>
            <p:nvPr/>
          </p:nvCxnSpPr>
          <p:spPr>
            <a:xfrm>
              <a:off x="1702843" y="4126371"/>
              <a:ext cx="5289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C1CEBD77-16D2-4E49-BA00-6029AAED57E7}"/>
                </a:ext>
              </a:extLst>
            </p:cNvPr>
            <p:cNvCxnSpPr>
              <a:cxnSpLocks/>
            </p:cNvCxnSpPr>
            <p:nvPr/>
          </p:nvCxnSpPr>
          <p:spPr>
            <a:xfrm>
              <a:off x="1702843" y="3028395"/>
              <a:ext cx="5289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73D4CCF0-45B6-5740-A9CD-A442DECEF986}"/>
                </a:ext>
              </a:extLst>
            </p:cNvPr>
            <p:cNvCxnSpPr>
              <a:cxnSpLocks/>
            </p:cNvCxnSpPr>
            <p:nvPr/>
          </p:nvCxnSpPr>
          <p:spPr>
            <a:xfrm>
              <a:off x="1702843" y="1930419"/>
              <a:ext cx="5289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244FAB58-287E-4645-BD90-6B9417D9C369}"/>
                </a:ext>
              </a:extLst>
            </p:cNvPr>
            <p:cNvCxnSpPr>
              <a:cxnSpLocks/>
            </p:cNvCxnSpPr>
            <p:nvPr/>
          </p:nvCxnSpPr>
          <p:spPr>
            <a:xfrm>
              <a:off x="1702843" y="3577383"/>
              <a:ext cx="5289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45C1B6D6-0A1E-CC40-8718-0CF816190FEC}"/>
                </a:ext>
              </a:extLst>
            </p:cNvPr>
            <p:cNvCxnSpPr>
              <a:cxnSpLocks/>
            </p:cNvCxnSpPr>
            <p:nvPr/>
          </p:nvCxnSpPr>
          <p:spPr>
            <a:xfrm>
              <a:off x="1702843" y="2479407"/>
              <a:ext cx="52892" cy="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</p:grpSp>
      <p:grpSp>
        <p:nvGrpSpPr>
          <p:cNvPr id="59" name="Group 58">
            <a:extLst>
              <a:ext uri="{FF2B5EF4-FFF2-40B4-BE49-F238E27FC236}">
                <a16:creationId xmlns:a16="http://schemas.microsoft.com/office/drawing/2014/main" id="{B5A8C357-FE91-2843-B71A-949AB1DD02B1}"/>
              </a:ext>
            </a:extLst>
          </p:cNvPr>
          <p:cNvGrpSpPr/>
          <p:nvPr/>
        </p:nvGrpSpPr>
        <p:grpSpPr>
          <a:xfrm>
            <a:off x="2345430" y="1787535"/>
            <a:ext cx="308407" cy="2869011"/>
            <a:chOff x="1354668" y="1867451"/>
            <a:chExt cx="308407" cy="2869011"/>
          </a:xfrm>
        </p:grpSpPr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6C891A5C-674A-E945-93DB-D6CDDD16B946}"/>
                </a:ext>
              </a:extLst>
            </p:cNvPr>
            <p:cNvSpPr txBox="1"/>
            <p:nvPr/>
          </p:nvSpPr>
          <p:spPr>
            <a:xfrm>
              <a:off x="1354668" y="1867451"/>
              <a:ext cx="308407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8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BF8D104-6D07-EC4E-A08A-3EEE38CB13DE}"/>
                </a:ext>
              </a:extLst>
            </p:cNvPr>
            <p:cNvSpPr txBox="1"/>
            <p:nvPr/>
          </p:nvSpPr>
          <p:spPr>
            <a:xfrm>
              <a:off x="1354668" y="2417446"/>
              <a:ext cx="308407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8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1A59CDBA-C63E-6949-B819-035657B24187}"/>
                </a:ext>
              </a:extLst>
            </p:cNvPr>
            <p:cNvSpPr txBox="1"/>
            <p:nvPr/>
          </p:nvSpPr>
          <p:spPr>
            <a:xfrm>
              <a:off x="1354668" y="2967441"/>
              <a:ext cx="308407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8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635AC5E2-E887-ED46-887A-71775562F8AB}"/>
                </a:ext>
              </a:extLst>
            </p:cNvPr>
            <p:cNvSpPr txBox="1"/>
            <p:nvPr/>
          </p:nvSpPr>
          <p:spPr>
            <a:xfrm>
              <a:off x="1354668" y="4067431"/>
              <a:ext cx="308407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300DEA04-A978-BE48-974C-6624AE74DFC2}"/>
                </a:ext>
              </a:extLst>
            </p:cNvPr>
            <p:cNvSpPr txBox="1"/>
            <p:nvPr/>
          </p:nvSpPr>
          <p:spPr>
            <a:xfrm>
              <a:off x="1354668" y="4617428"/>
              <a:ext cx="308407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5410D409-4AF0-9B44-B73D-EEB0541BEE1F}"/>
                </a:ext>
              </a:extLst>
            </p:cNvPr>
            <p:cNvSpPr txBox="1"/>
            <p:nvPr/>
          </p:nvSpPr>
          <p:spPr>
            <a:xfrm>
              <a:off x="1354668" y="3517436"/>
              <a:ext cx="308407" cy="119034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r"/>
              <a:r>
                <a:rPr lang="en-RO" sz="8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</p:grpSp>
      <p:sp>
        <p:nvSpPr>
          <p:cNvPr id="66" name="TextBox 65">
            <a:extLst>
              <a:ext uri="{FF2B5EF4-FFF2-40B4-BE49-F238E27FC236}">
                <a16:creationId xmlns:a16="http://schemas.microsoft.com/office/drawing/2014/main" id="{E23A549C-C5ED-8C4A-AE01-FCF97995D239}"/>
              </a:ext>
            </a:extLst>
          </p:cNvPr>
          <p:cNvSpPr txBox="1"/>
          <p:nvPr/>
        </p:nvSpPr>
        <p:spPr>
          <a:xfrm rot="16200000">
            <a:off x="983241" y="3107463"/>
            <a:ext cx="27624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RO" sz="900" b="1" dirty="0">
                <a:latin typeface="Arial" panose="020B0604020202020204" pitchFamily="34" charset="0"/>
                <a:cs typeface="Arial" panose="020B0604020202020204" pitchFamily="34" charset="0"/>
              </a:rPr>
              <a:t>Mean with 95% CI</a:t>
            </a:r>
          </a:p>
        </p:txBody>
      </p:sp>
      <p:grpSp>
        <p:nvGrpSpPr>
          <p:cNvPr id="67" name="Group 66">
            <a:extLst>
              <a:ext uri="{FF2B5EF4-FFF2-40B4-BE49-F238E27FC236}">
                <a16:creationId xmlns:a16="http://schemas.microsoft.com/office/drawing/2014/main" id="{D8635067-71A8-3649-9493-FDE1CD186CFA}"/>
              </a:ext>
            </a:extLst>
          </p:cNvPr>
          <p:cNvGrpSpPr/>
          <p:nvPr/>
        </p:nvGrpSpPr>
        <p:grpSpPr>
          <a:xfrm>
            <a:off x="2813172" y="4595441"/>
            <a:ext cx="5774650" cy="54000"/>
            <a:chOff x="1603335" y="4675357"/>
            <a:chExt cx="5774650" cy="54000"/>
          </a:xfrm>
        </p:grpSpPr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BC562AC9-1975-DD47-9F6F-D8CC316EC1D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03335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C30D7389-F76F-9443-B7F8-4A65F6503DB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06217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3180D912-C226-1D41-9E6B-08A335ABDEB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409099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6B6C66F1-2FDA-A84E-AEFA-45A2AD6121E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43393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622E671A-49F3-494E-A485-37F3D6ED033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77687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42BE2A6D-9BC7-9941-A93A-2D9F4313A25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11981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82CFCAB6-E571-7243-9072-2A10FB317B0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946275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E4BA88FC-A02A-3E40-845F-707E70FC955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80569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F677DD65-0D2F-A64E-A648-5C204970E2D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214863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49A35586-F73E-F34F-98CD-A5D4BD716C3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49157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6B0A3BF1-EC6F-6547-8CF0-B95897336EA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83451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FFF14F09-4FB6-6E48-997E-09E15F655C2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17745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5984B8AE-D743-3B49-BFD2-F8083D437AE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52039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8728679A-D8D4-774C-9BBC-4C269FEF636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86333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4DFD88BD-201D-404D-A48F-D3EECBD1B4C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20627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9F258B36-FA2A-7845-BBED-56878EEC53C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154921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17E9D399-B70F-A341-BCC2-3519A3E61CD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89215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13F2BCC3-5657-0B41-A73E-6DD17DF6DB3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423509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45DD10FE-794C-BB42-AA12-930BE387324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557803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41681E1F-5E34-4340-BDAD-5249A13526F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692097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AC88C2AB-483D-5241-8B2C-4F13DFD95CA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26391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4EC7EF2D-CB57-AE4D-93EF-179BF02765D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60685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21CCBF9E-30BE-4541-9BD2-4ADEEA6017B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94979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2C44E638-F628-4A4E-A6F4-C8707F65072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29273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A2D54EBA-AB93-0541-A62A-CD8462D73E0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363567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85087705-B046-2B42-9B94-64153403A1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97861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66C74C8E-2960-704A-971E-E849AC20637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32155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3E60B10B-3400-E948-BD46-349D91C2A22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766449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30F72CBF-6D7F-1A44-86B1-B99629860F4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00743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2F08BD6E-7A56-5749-9459-A673F5C1027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35037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353266DC-5EB3-6D46-BD32-57D0541FFC6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69331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05FBB354-C6B7-3845-B4FD-A165FE93E03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303625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15F32CE6-C72F-C947-AC2E-05F16281A85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37919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D74723CD-B4F0-AD4D-A729-99C3618545B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72213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125DDF86-6321-3746-AD85-92E4369E5FA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706507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D0743CB6-733F-514F-817D-F8C2D735AAE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840801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4D9D24E9-387C-9743-B5E6-DFCD50C7989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975095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DF8790A7-CCF7-4445-BD8B-041D9562351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109389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A0EBE31A-CEB5-7D4A-93BF-FA75F75B226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243683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D9881818-95E8-984F-B114-1779EA77440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377985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DA9199F3-9C40-B34A-8937-B528E74CF95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37629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8C3FA316-48FA-D742-9A41-DF9528B0F5C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74805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E028FBC5-BBAD-1B47-86BC-66F9FDCCC66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71923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AAAFF037-0C3E-D246-909E-251A4E17D05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140511" y="4675357"/>
              <a:ext cx="0" cy="54000"/>
            </a:xfrm>
            <a:prstGeom prst="line">
              <a:avLst/>
            </a:prstGeom>
            <a:noFill/>
            <a:ln w="12700" cap="flat" cmpd="sng" algn="ctr">
              <a:solidFill>
                <a:srgbClr val="454347"/>
              </a:solidFill>
              <a:prstDash val="solid"/>
            </a:ln>
            <a:effectLst/>
          </p:spPr>
        </p:cxnSp>
      </p:grpSp>
      <p:grpSp>
        <p:nvGrpSpPr>
          <p:cNvPr id="112" name="Group 111">
            <a:extLst>
              <a:ext uri="{FF2B5EF4-FFF2-40B4-BE49-F238E27FC236}">
                <a16:creationId xmlns:a16="http://schemas.microsoft.com/office/drawing/2014/main" id="{A0F948A3-2616-C54C-9A0E-E6C8D99F3808}"/>
              </a:ext>
            </a:extLst>
          </p:cNvPr>
          <p:cNvGrpSpPr/>
          <p:nvPr/>
        </p:nvGrpSpPr>
        <p:grpSpPr>
          <a:xfrm>
            <a:off x="2768605" y="2131947"/>
            <a:ext cx="5592762" cy="1169988"/>
            <a:chOff x="375598" y="1582661"/>
            <a:chExt cx="5592762" cy="1169988"/>
          </a:xfrm>
        </p:grpSpPr>
        <p:sp>
          <p:nvSpPr>
            <p:cNvPr id="113" name="Freeform 5">
              <a:extLst>
                <a:ext uri="{FF2B5EF4-FFF2-40B4-BE49-F238E27FC236}">
                  <a16:creationId xmlns:a16="http://schemas.microsoft.com/office/drawing/2014/main" id="{A1D6908D-3A92-5244-9171-6A0CAF155954}"/>
                </a:ext>
              </a:extLst>
            </p:cNvPr>
            <p:cNvSpPr>
              <a:spLocks/>
            </p:cNvSpPr>
            <p:nvPr/>
          </p:nvSpPr>
          <p:spPr bwMode="auto">
            <a:xfrm>
              <a:off x="416873" y="1757286"/>
              <a:ext cx="4702175" cy="912813"/>
            </a:xfrm>
            <a:custGeom>
              <a:avLst/>
              <a:gdLst>
                <a:gd name="T0" fmla="*/ 0 w 6169"/>
                <a:gd name="T1" fmla="*/ 655 h 1198"/>
                <a:gd name="T2" fmla="*/ 177 w 6169"/>
                <a:gd name="T3" fmla="*/ 690 h 1198"/>
                <a:gd name="T4" fmla="*/ 352 w 6169"/>
                <a:gd name="T5" fmla="*/ 745 h 1198"/>
                <a:gd name="T6" fmla="*/ 529 w 6169"/>
                <a:gd name="T7" fmla="*/ 677 h 1198"/>
                <a:gd name="T8" fmla="*/ 703 w 6169"/>
                <a:gd name="T9" fmla="*/ 527 h 1198"/>
                <a:gd name="T10" fmla="*/ 883 w 6169"/>
                <a:gd name="T11" fmla="*/ 535 h 1198"/>
                <a:gd name="T12" fmla="*/ 1057 w 6169"/>
                <a:gd name="T13" fmla="*/ 534 h 1198"/>
                <a:gd name="T14" fmla="*/ 1233 w 6169"/>
                <a:gd name="T15" fmla="*/ 407 h 1198"/>
                <a:gd name="T16" fmla="*/ 1411 w 6169"/>
                <a:gd name="T17" fmla="*/ 525 h 1198"/>
                <a:gd name="T18" fmla="*/ 1585 w 6169"/>
                <a:gd name="T19" fmla="*/ 442 h 1198"/>
                <a:gd name="T20" fmla="*/ 1764 w 6169"/>
                <a:gd name="T21" fmla="*/ 654 h 1198"/>
                <a:gd name="T22" fmla="*/ 1940 w 6169"/>
                <a:gd name="T23" fmla="*/ 394 h 1198"/>
                <a:gd name="T24" fmla="*/ 2115 w 6169"/>
                <a:gd name="T25" fmla="*/ 416 h 1198"/>
                <a:gd name="T26" fmla="*/ 2292 w 6169"/>
                <a:gd name="T27" fmla="*/ 300 h 1198"/>
                <a:gd name="T28" fmla="*/ 2471 w 6169"/>
                <a:gd name="T29" fmla="*/ 541 h 1198"/>
                <a:gd name="T30" fmla="*/ 2644 w 6169"/>
                <a:gd name="T31" fmla="*/ 544 h 1198"/>
                <a:gd name="T32" fmla="*/ 2822 w 6169"/>
                <a:gd name="T33" fmla="*/ 465 h 1198"/>
                <a:gd name="T34" fmla="*/ 2998 w 6169"/>
                <a:gd name="T35" fmla="*/ 249 h 1198"/>
                <a:gd name="T36" fmla="*/ 3174 w 6169"/>
                <a:gd name="T37" fmla="*/ 352 h 1198"/>
                <a:gd name="T38" fmla="*/ 3351 w 6169"/>
                <a:gd name="T39" fmla="*/ 384 h 1198"/>
                <a:gd name="T40" fmla="*/ 3527 w 6169"/>
                <a:gd name="T41" fmla="*/ 469 h 1198"/>
                <a:gd name="T42" fmla="*/ 3703 w 6169"/>
                <a:gd name="T43" fmla="*/ 564 h 1198"/>
                <a:gd name="T44" fmla="*/ 3878 w 6169"/>
                <a:gd name="T45" fmla="*/ 617 h 1198"/>
                <a:gd name="T46" fmla="*/ 4056 w 6169"/>
                <a:gd name="T47" fmla="*/ 539 h 1198"/>
                <a:gd name="T48" fmla="*/ 4232 w 6169"/>
                <a:gd name="T49" fmla="*/ 523 h 1198"/>
                <a:gd name="T50" fmla="*/ 4408 w 6169"/>
                <a:gd name="T51" fmla="*/ 733 h 1198"/>
                <a:gd name="T52" fmla="*/ 4585 w 6169"/>
                <a:gd name="T53" fmla="*/ 600 h 1198"/>
                <a:gd name="T54" fmla="*/ 4762 w 6169"/>
                <a:gd name="T55" fmla="*/ 480 h 1198"/>
                <a:gd name="T56" fmla="*/ 4935 w 6169"/>
                <a:gd name="T57" fmla="*/ 433 h 1198"/>
                <a:gd name="T58" fmla="*/ 5111 w 6169"/>
                <a:gd name="T59" fmla="*/ 594 h 1198"/>
                <a:gd name="T60" fmla="*/ 5286 w 6169"/>
                <a:gd name="T61" fmla="*/ 543 h 1198"/>
                <a:gd name="T62" fmla="*/ 5466 w 6169"/>
                <a:gd name="T63" fmla="*/ 1198 h 1198"/>
                <a:gd name="T64" fmla="*/ 5644 w 6169"/>
                <a:gd name="T65" fmla="*/ 598 h 1198"/>
                <a:gd name="T66" fmla="*/ 5820 w 6169"/>
                <a:gd name="T67" fmla="*/ 0 h 1198"/>
                <a:gd name="T68" fmla="*/ 5991 w 6169"/>
                <a:gd name="T69" fmla="*/ 1 h 1198"/>
                <a:gd name="T70" fmla="*/ 6169 w 6169"/>
                <a:gd name="T71" fmla="*/ 0 h 11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6169" h="1198">
                  <a:moveTo>
                    <a:pt x="0" y="655"/>
                  </a:moveTo>
                  <a:lnTo>
                    <a:pt x="177" y="690"/>
                  </a:lnTo>
                  <a:lnTo>
                    <a:pt x="352" y="745"/>
                  </a:lnTo>
                  <a:lnTo>
                    <a:pt x="529" y="677"/>
                  </a:lnTo>
                  <a:lnTo>
                    <a:pt x="703" y="527"/>
                  </a:lnTo>
                  <a:lnTo>
                    <a:pt x="883" y="535"/>
                  </a:lnTo>
                  <a:lnTo>
                    <a:pt x="1057" y="534"/>
                  </a:lnTo>
                  <a:lnTo>
                    <a:pt x="1233" y="407"/>
                  </a:lnTo>
                  <a:lnTo>
                    <a:pt x="1411" y="525"/>
                  </a:lnTo>
                  <a:lnTo>
                    <a:pt x="1585" y="442"/>
                  </a:lnTo>
                  <a:lnTo>
                    <a:pt x="1764" y="654"/>
                  </a:lnTo>
                  <a:lnTo>
                    <a:pt x="1940" y="394"/>
                  </a:lnTo>
                  <a:lnTo>
                    <a:pt x="2115" y="416"/>
                  </a:lnTo>
                  <a:lnTo>
                    <a:pt x="2292" y="300"/>
                  </a:lnTo>
                  <a:lnTo>
                    <a:pt x="2471" y="541"/>
                  </a:lnTo>
                  <a:lnTo>
                    <a:pt x="2644" y="544"/>
                  </a:lnTo>
                  <a:lnTo>
                    <a:pt x="2822" y="465"/>
                  </a:lnTo>
                  <a:lnTo>
                    <a:pt x="2998" y="249"/>
                  </a:lnTo>
                  <a:lnTo>
                    <a:pt x="3174" y="352"/>
                  </a:lnTo>
                  <a:lnTo>
                    <a:pt x="3351" y="384"/>
                  </a:lnTo>
                  <a:lnTo>
                    <a:pt x="3527" y="469"/>
                  </a:lnTo>
                  <a:lnTo>
                    <a:pt x="3703" y="564"/>
                  </a:lnTo>
                  <a:lnTo>
                    <a:pt x="3878" y="617"/>
                  </a:lnTo>
                  <a:lnTo>
                    <a:pt x="4056" y="539"/>
                  </a:lnTo>
                  <a:lnTo>
                    <a:pt x="4232" y="523"/>
                  </a:lnTo>
                  <a:lnTo>
                    <a:pt x="4408" y="733"/>
                  </a:lnTo>
                  <a:lnTo>
                    <a:pt x="4585" y="600"/>
                  </a:lnTo>
                  <a:lnTo>
                    <a:pt x="4762" y="480"/>
                  </a:lnTo>
                  <a:lnTo>
                    <a:pt x="4935" y="433"/>
                  </a:lnTo>
                  <a:lnTo>
                    <a:pt x="5111" y="594"/>
                  </a:lnTo>
                  <a:lnTo>
                    <a:pt x="5286" y="543"/>
                  </a:lnTo>
                  <a:lnTo>
                    <a:pt x="5466" y="1198"/>
                  </a:lnTo>
                  <a:lnTo>
                    <a:pt x="5644" y="598"/>
                  </a:lnTo>
                  <a:lnTo>
                    <a:pt x="5820" y="0"/>
                  </a:lnTo>
                  <a:lnTo>
                    <a:pt x="5991" y="1"/>
                  </a:lnTo>
                  <a:lnTo>
                    <a:pt x="6169" y="0"/>
                  </a:lnTo>
                </a:path>
              </a:pathLst>
            </a:custGeom>
            <a:noFill/>
            <a:ln w="19050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Line 6">
              <a:extLst>
                <a:ext uri="{FF2B5EF4-FFF2-40B4-BE49-F238E27FC236}">
                  <a16:creationId xmlns:a16="http://schemas.microsoft.com/office/drawing/2014/main" id="{DBC94093-AB7F-E24F-A826-3A7BE825D2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88985" y="2184323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Line 7">
              <a:extLst>
                <a:ext uri="{FF2B5EF4-FFF2-40B4-BE49-F238E27FC236}">
                  <a16:creationId xmlns:a16="http://schemas.microsoft.com/office/drawing/2014/main" id="{C00CAC82-C7A8-CB44-882C-BF1B39D73A9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88985" y="273518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Line 8">
              <a:extLst>
                <a:ext uri="{FF2B5EF4-FFF2-40B4-BE49-F238E27FC236}">
                  <a16:creationId xmlns:a16="http://schemas.microsoft.com/office/drawing/2014/main" id="{43788C4A-B784-584B-B0CC-A728EE1C51D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928673" y="2182736"/>
              <a:ext cx="0" cy="55245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Line 9">
              <a:extLst>
                <a:ext uri="{FF2B5EF4-FFF2-40B4-BE49-F238E27FC236}">
                  <a16:creationId xmlns:a16="http://schemas.microsoft.com/office/drawing/2014/main" id="{68A3E6B7-5E18-EE4F-9D8D-E86D360838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11023" y="1584248"/>
              <a:ext cx="77788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Line 10">
              <a:extLst>
                <a:ext uri="{FF2B5EF4-FFF2-40B4-BE49-F238E27FC236}">
                  <a16:creationId xmlns:a16="http://schemas.microsoft.com/office/drawing/2014/main" id="{28B65330-D014-6B4A-80E5-617D56C9B4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11023" y="2752648"/>
              <a:ext cx="77788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Line 11">
              <a:extLst>
                <a:ext uri="{FF2B5EF4-FFF2-40B4-BE49-F238E27FC236}">
                  <a16:creationId xmlns:a16="http://schemas.microsoft.com/office/drawing/2014/main" id="{69F92CE6-AF05-7A4F-B83D-7AF32ADCB7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450710" y="1582661"/>
              <a:ext cx="0" cy="1169988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Line 12">
              <a:extLst>
                <a:ext uri="{FF2B5EF4-FFF2-40B4-BE49-F238E27FC236}">
                  <a16:creationId xmlns:a16="http://schemas.microsoft.com/office/drawing/2014/main" id="{D8C6E524-2F4D-1A4A-97B3-9E1A83F803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74498" y="185888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Line 13">
              <a:extLst>
                <a:ext uri="{FF2B5EF4-FFF2-40B4-BE49-F238E27FC236}">
                  <a16:creationId xmlns:a16="http://schemas.microsoft.com/office/drawing/2014/main" id="{91EBEA68-A1F8-5D4E-9508-1ECDDB0D9F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74498" y="256849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Line 14">
              <a:extLst>
                <a:ext uri="{FF2B5EF4-FFF2-40B4-BE49-F238E27FC236}">
                  <a16:creationId xmlns:a16="http://schemas.microsoft.com/office/drawing/2014/main" id="{B08430C6-7F02-6649-9515-4E0C0E8A5D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14185" y="1857298"/>
              <a:ext cx="0" cy="71120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Line 15">
              <a:extLst>
                <a:ext uri="{FF2B5EF4-FFF2-40B4-BE49-F238E27FC236}">
                  <a16:creationId xmlns:a16="http://schemas.microsoft.com/office/drawing/2014/main" id="{7F41DC2A-66B7-C749-831A-BAA98F0590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41148" y="174934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Line 16">
              <a:extLst>
                <a:ext uri="{FF2B5EF4-FFF2-40B4-BE49-F238E27FC236}">
                  <a16:creationId xmlns:a16="http://schemas.microsoft.com/office/drawing/2014/main" id="{6353B855-AF69-CE47-B062-4E060A80E29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41148" y="2431973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Line 17">
              <a:extLst>
                <a:ext uri="{FF2B5EF4-FFF2-40B4-BE49-F238E27FC236}">
                  <a16:creationId xmlns:a16="http://schemas.microsoft.com/office/drawing/2014/main" id="{E49715B2-438E-3340-B53B-5200755CAC5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80835" y="1747761"/>
              <a:ext cx="0" cy="684213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Line 18">
              <a:extLst>
                <a:ext uri="{FF2B5EF4-FFF2-40B4-BE49-F238E27FC236}">
                  <a16:creationId xmlns:a16="http://schemas.microsoft.com/office/drawing/2014/main" id="{3431D09C-94A4-FB48-84E6-0CC3EBAEB9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04623" y="178109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Line 19">
              <a:extLst>
                <a:ext uri="{FF2B5EF4-FFF2-40B4-BE49-F238E27FC236}">
                  <a16:creationId xmlns:a16="http://schemas.microsoft.com/office/drawing/2014/main" id="{976204EF-28B0-EA4F-8BE9-48237E6336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04623" y="2463723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Line 20">
              <a:extLst>
                <a:ext uri="{FF2B5EF4-FFF2-40B4-BE49-F238E27FC236}">
                  <a16:creationId xmlns:a16="http://schemas.microsoft.com/office/drawing/2014/main" id="{949BB19C-DF9B-D940-A3DE-ADF118F282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44310" y="1779511"/>
              <a:ext cx="0" cy="68580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Line 21">
              <a:extLst>
                <a:ext uri="{FF2B5EF4-FFF2-40B4-BE49-F238E27FC236}">
                  <a16:creationId xmlns:a16="http://schemas.microsoft.com/office/drawing/2014/main" id="{F99CBEA6-06C1-CC45-839F-8166F575FD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71273" y="179856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Line 22">
              <a:extLst>
                <a:ext uri="{FF2B5EF4-FFF2-40B4-BE49-F238E27FC236}">
                  <a16:creationId xmlns:a16="http://schemas.microsoft.com/office/drawing/2014/main" id="{6ADBFC08-B424-5647-BFFB-09B2F588BC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71273" y="262406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Line 23">
              <a:extLst>
                <a:ext uri="{FF2B5EF4-FFF2-40B4-BE49-F238E27FC236}">
                  <a16:creationId xmlns:a16="http://schemas.microsoft.com/office/drawing/2014/main" id="{8849FF6C-E6F3-9144-90E5-9F7FF19BE1B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10960" y="1796973"/>
              <a:ext cx="0" cy="827088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Line 24">
              <a:extLst>
                <a:ext uri="{FF2B5EF4-FFF2-40B4-BE49-F238E27FC236}">
                  <a16:creationId xmlns:a16="http://schemas.microsoft.com/office/drawing/2014/main" id="{EA3976F4-4AE2-154A-A111-511DCF538B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39510" y="1933498"/>
              <a:ext cx="77788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Line 25">
              <a:extLst>
                <a:ext uri="{FF2B5EF4-FFF2-40B4-BE49-F238E27FC236}">
                  <a16:creationId xmlns:a16="http://schemas.microsoft.com/office/drawing/2014/main" id="{F50C61D7-7D32-744E-9A75-C93810A62D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39510" y="2428798"/>
              <a:ext cx="77788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Line 26">
              <a:extLst>
                <a:ext uri="{FF2B5EF4-FFF2-40B4-BE49-F238E27FC236}">
                  <a16:creationId xmlns:a16="http://schemas.microsoft.com/office/drawing/2014/main" id="{12077ED5-D2FA-8244-BC32-E107BF8714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779198" y="1931911"/>
              <a:ext cx="0" cy="496888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Line 27">
              <a:extLst>
                <a:ext uri="{FF2B5EF4-FFF2-40B4-BE49-F238E27FC236}">
                  <a16:creationId xmlns:a16="http://schemas.microsoft.com/office/drawing/2014/main" id="{C7834306-CA20-2D47-A9C6-44A886B355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04573" y="194143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Line 28">
              <a:extLst>
                <a:ext uri="{FF2B5EF4-FFF2-40B4-BE49-F238E27FC236}">
                  <a16:creationId xmlns:a16="http://schemas.microsoft.com/office/drawing/2014/main" id="{0FBE6459-648A-A74F-BC22-B2A1E73AD3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04573" y="237323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Line 29">
              <a:extLst>
                <a:ext uri="{FF2B5EF4-FFF2-40B4-BE49-F238E27FC236}">
                  <a16:creationId xmlns:a16="http://schemas.microsoft.com/office/drawing/2014/main" id="{9CF8AACB-FE54-4F41-9650-17DAD52D899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44260" y="1939848"/>
              <a:ext cx="0" cy="433388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Line 30">
              <a:extLst>
                <a:ext uri="{FF2B5EF4-FFF2-40B4-BE49-F238E27FC236}">
                  <a16:creationId xmlns:a16="http://schemas.microsoft.com/office/drawing/2014/main" id="{2F83FA13-0408-0941-81C8-73FD435CC2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9635" y="192079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Line 31">
              <a:extLst>
                <a:ext uri="{FF2B5EF4-FFF2-40B4-BE49-F238E27FC236}">
                  <a16:creationId xmlns:a16="http://schemas.microsoft.com/office/drawing/2014/main" id="{45DE5486-F0C6-7947-8FD2-5CF92FBA42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9635" y="241451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Line 32">
              <a:extLst>
                <a:ext uri="{FF2B5EF4-FFF2-40B4-BE49-F238E27FC236}">
                  <a16:creationId xmlns:a16="http://schemas.microsoft.com/office/drawing/2014/main" id="{131C8949-63A8-274D-BF31-3F849096F6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09323" y="1919211"/>
              <a:ext cx="0" cy="49530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Line 33">
              <a:extLst>
                <a:ext uri="{FF2B5EF4-FFF2-40B4-BE49-F238E27FC236}">
                  <a16:creationId xmlns:a16="http://schemas.microsoft.com/office/drawing/2014/main" id="{ECA27094-383D-BB46-AC8C-74E80BA699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6285" y="194619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Line 34">
              <a:extLst>
                <a:ext uri="{FF2B5EF4-FFF2-40B4-BE49-F238E27FC236}">
                  <a16:creationId xmlns:a16="http://schemas.microsoft.com/office/drawing/2014/main" id="{316A7728-D8AB-C84C-8B5F-0075CC407C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36285" y="250976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Line 35">
              <a:extLst>
                <a:ext uri="{FF2B5EF4-FFF2-40B4-BE49-F238E27FC236}">
                  <a16:creationId xmlns:a16="http://schemas.microsoft.com/office/drawing/2014/main" id="{21EC7DE0-6BEC-EB46-98AE-5EE7957BB64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375973" y="1944611"/>
              <a:ext cx="0" cy="56515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Line 36">
              <a:extLst>
                <a:ext uri="{FF2B5EF4-FFF2-40B4-BE49-F238E27FC236}">
                  <a16:creationId xmlns:a16="http://schemas.microsoft.com/office/drawing/2014/main" id="{35290DA4-FB08-9E49-AC31-3F9040663D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9760" y="190651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Line 37">
              <a:extLst>
                <a:ext uri="{FF2B5EF4-FFF2-40B4-BE49-F238E27FC236}">
                  <a16:creationId xmlns:a16="http://schemas.microsoft.com/office/drawing/2014/main" id="{AD456C68-4068-6A45-A430-717D52B85E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99760" y="246531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Line 38">
              <a:extLst>
                <a:ext uri="{FF2B5EF4-FFF2-40B4-BE49-F238E27FC236}">
                  <a16:creationId xmlns:a16="http://schemas.microsoft.com/office/drawing/2014/main" id="{AC2CF07E-1CA5-7347-811C-152904E1497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39448" y="1904923"/>
              <a:ext cx="0" cy="560388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Line 39">
              <a:extLst>
                <a:ext uri="{FF2B5EF4-FFF2-40B4-BE49-F238E27FC236}">
                  <a16:creationId xmlns:a16="http://schemas.microsoft.com/office/drawing/2014/main" id="{3762730D-E738-E24B-8A17-99CCAD5560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6410" y="188428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Line 40">
              <a:extLst>
                <a:ext uri="{FF2B5EF4-FFF2-40B4-BE49-F238E27FC236}">
                  <a16:creationId xmlns:a16="http://schemas.microsoft.com/office/drawing/2014/main" id="{AAD33A02-4A00-5546-B2D6-EF01A8A51C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6410" y="234466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Line 41">
              <a:extLst>
                <a:ext uri="{FF2B5EF4-FFF2-40B4-BE49-F238E27FC236}">
                  <a16:creationId xmlns:a16="http://schemas.microsoft.com/office/drawing/2014/main" id="{25637774-06A1-FD48-B8BB-823C62B926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06098" y="1882698"/>
              <a:ext cx="0" cy="461963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Line 42">
              <a:extLst>
                <a:ext uri="{FF2B5EF4-FFF2-40B4-BE49-F238E27FC236}">
                  <a16:creationId xmlns:a16="http://schemas.microsoft.com/office/drawing/2014/main" id="{3342AFDB-4043-7B4E-859C-5A98208C05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33060" y="186841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Line 43">
              <a:extLst>
                <a:ext uri="{FF2B5EF4-FFF2-40B4-BE49-F238E27FC236}">
                  <a16:creationId xmlns:a16="http://schemas.microsoft.com/office/drawing/2014/main" id="{7AB8D62D-AB10-8F47-A453-B1B632214BC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33060" y="2235123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Line 44">
              <a:extLst>
                <a:ext uri="{FF2B5EF4-FFF2-40B4-BE49-F238E27FC236}">
                  <a16:creationId xmlns:a16="http://schemas.microsoft.com/office/drawing/2014/main" id="{1CDBA504-7BFA-8F45-9D26-4A5FBCA2CE8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972748" y="1866823"/>
              <a:ext cx="0" cy="36830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Line 45">
              <a:extLst>
                <a:ext uri="{FF2B5EF4-FFF2-40B4-BE49-F238E27FC236}">
                  <a16:creationId xmlns:a16="http://schemas.microsoft.com/office/drawing/2014/main" id="{B55491F0-5715-0B44-854E-B809362E08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8123" y="182554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Line 46">
              <a:extLst>
                <a:ext uri="{FF2B5EF4-FFF2-40B4-BE49-F238E27FC236}">
                  <a16:creationId xmlns:a16="http://schemas.microsoft.com/office/drawing/2014/main" id="{C76F207B-DAC9-B64F-B196-9AE2F9A1BC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98123" y="222559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Line 47">
              <a:extLst>
                <a:ext uri="{FF2B5EF4-FFF2-40B4-BE49-F238E27FC236}">
                  <a16:creationId xmlns:a16="http://schemas.microsoft.com/office/drawing/2014/main" id="{7DA49765-E053-7047-A446-6F2C63424B0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37810" y="1823961"/>
              <a:ext cx="0" cy="401638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Line 48">
              <a:extLst>
                <a:ext uri="{FF2B5EF4-FFF2-40B4-BE49-F238E27FC236}">
                  <a16:creationId xmlns:a16="http://schemas.microsoft.com/office/drawing/2014/main" id="{4CCDC67A-D8F4-1E4B-945C-40776372E6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63185" y="1769986"/>
              <a:ext cx="77788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Line 49">
              <a:extLst>
                <a:ext uri="{FF2B5EF4-FFF2-40B4-BE49-F238E27FC236}">
                  <a16:creationId xmlns:a16="http://schemas.microsoft.com/office/drawing/2014/main" id="{7BC7D9A4-0B65-8D43-8A6E-D625D53F87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63185" y="2117648"/>
              <a:ext cx="77788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Line 50">
              <a:extLst>
                <a:ext uri="{FF2B5EF4-FFF2-40B4-BE49-F238E27FC236}">
                  <a16:creationId xmlns:a16="http://schemas.microsoft.com/office/drawing/2014/main" id="{D17649A0-44A6-2347-A87A-784C00C4158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701285" y="1768398"/>
              <a:ext cx="0" cy="34925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Line 51">
              <a:extLst>
                <a:ext uri="{FF2B5EF4-FFF2-40B4-BE49-F238E27FC236}">
                  <a16:creationId xmlns:a16="http://schemas.microsoft.com/office/drawing/2014/main" id="{1470C82D-A2B5-0447-95F5-6C20CBFE86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9835" y="1919211"/>
              <a:ext cx="77788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Line 52">
              <a:extLst>
                <a:ext uri="{FF2B5EF4-FFF2-40B4-BE49-F238E27FC236}">
                  <a16:creationId xmlns:a16="http://schemas.microsoft.com/office/drawing/2014/main" id="{593F3973-58D3-2947-93D8-3C0509EF52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9835" y="2303386"/>
              <a:ext cx="77788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Line 53">
              <a:extLst>
                <a:ext uri="{FF2B5EF4-FFF2-40B4-BE49-F238E27FC236}">
                  <a16:creationId xmlns:a16="http://schemas.microsoft.com/office/drawing/2014/main" id="{2D54843D-C806-1A43-88BB-14C227B7633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67935" y="1917623"/>
              <a:ext cx="0" cy="385763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Line 54">
              <a:extLst>
                <a:ext uri="{FF2B5EF4-FFF2-40B4-BE49-F238E27FC236}">
                  <a16:creationId xmlns:a16="http://schemas.microsoft.com/office/drawing/2014/main" id="{228E744C-5582-2F4F-9C2C-FA4583875F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3310" y="1974773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Line 55">
              <a:extLst>
                <a:ext uri="{FF2B5EF4-FFF2-40B4-BE49-F238E27FC236}">
                  <a16:creationId xmlns:a16="http://schemas.microsoft.com/office/drawing/2014/main" id="{CE57C556-5EFD-D441-8A93-B36A8198FD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93310" y="2368473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Line 56">
              <a:extLst>
                <a:ext uri="{FF2B5EF4-FFF2-40B4-BE49-F238E27FC236}">
                  <a16:creationId xmlns:a16="http://schemas.microsoft.com/office/drawing/2014/main" id="{64AFB334-B041-D149-8C93-2959CB7DF8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432998" y="1973186"/>
              <a:ext cx="0" cy="396875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Line 57">
              <a:extLst>
                <a:ext uri="{FF2B5EF4-FFF2-40B4-BE49-F238E27FC236}">
                  <a16:creationId xmlns:a16="http://schemas.microsoft.com/office/drawing/2014/main" id="{F85CF250-25B8-3541-B5CB-4B6BAB4982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8373" y="192714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Line 58">
              <a:extLst>
                <a:ext uri="{FF2B5EF4-FFF2-40B4-BE49-F238E27FC236}">
                  <a16:creationId xmlns:a16="http://schemas.microsoft.com/office/drawing/2014/main" id="{0BCCF8B7-DF90-4F40-A52B-C2B78715D2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8373" y="241609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Line 59">
              <a:extLst>
                <a:ext uri="{FF2B5EF4-FFF2-40B4-BE49-F238E27FC236}">
                  <a16:creationId xmlns:a16="http://schemas.microsoft.com/office/drawing/2014/main" id="{DB553391-0C99-7147-86EA-730BFFB6727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98060" y="1925561"/>
              <a:ext cx="0" cy="490538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Line 60">
              <a:extLst>
                <a:ext uri="{FF2B5EF4-FFF2-40B4-BE49-F238E27FC236}">
                  <a16:creationId xmlns:a16="http://schemas.microsoft.com/office/drawing/2014/main" id="{101ED9E1-37CF-C44C-B08C-358BCE167E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3435" y="181443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Line 61">
              <a:extLst>
                <a:ext uri="{FF2B5EF4-FFF2-40B4-BE49-F238E27FC236}">
                  <a16:creationId xmlns:a16="http://schemas.microsoft.com/office/drawing/2014/main" id="{0F9F068A-EB13-FF4D-9467-DA71FFFEE3D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3435" y="214939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Line 62">
              <a:extLst>
                <a:ext uri="{FF2B5EF4-FFF2-40B4-BE49-F238E27FC236}">
                  <a16:creationId xmlns:a16="http://schemas.microsoft.com/office/drawing/2014/main" id="{49E23977-0747-F34F-B1CA-869130A994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63123" y="1814436"/>
              <a:ext cx="0" cy="334963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Line 63">
              <a:extLst>
                <a:ext uri="{FF2B5EF4-FFF2-40B4-BE49-F238E27FC236}">
                  <a16:creationId xmlns:a16="http://schemas.microsoft.com/office/drawing/2014/main" id="{14EF8274-396D-2740-A992-081DC9059C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90085" y="1930323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Line 64">
              <a:extLst>
                <a:ext uri="{FF2B5EF4-FFF2-40B4-BE49-F238E27FC236}">
                  <a16:creationId xmlns:a16="http://schemas.microsoft.com/office/drawing/2014/main" id="{732185DD-71B9-2145-B7FE-D2643E1ACD3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90085" y="222401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Line 65">
              <a:extLst>
                <a:ext uri="{FF2B5EF4-FFF2-40B4-BE49-F238E27FC236}">
                  <a16:creationId xmlns:a16="http://schemas.microsoft.com/office/drawing/2014/main" id="{DEE47BFD-8968-1543-8BB4-B5076868E8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29773" y="1930323"/>
              <a:ext cx="0" cy="293688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Line 66">
              <a:extLst>
                <a:ext uri="{FF2B5EF4-FFF2-40B4-BE49-F238E27FC236}">
                  <a16:creationId xmlns:a16="http://schemas.microsoft.com/office/drawing/2014/main" id="{24B5FBB7-F107-814B-BD35-465939A6CA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53560" y="189381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Line 67">
              <a:extLst>
                <a:ext uri="{FF2B5EF4-FFF2-40B4-BE49-F238E27FC236}">
                  <a16:creationId xmlns:a16="http://schemas.microsoft.com/office/drawing/2014/main" id="{A4989003-87C3-7549-8096-749F1575E81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53560" y="2209723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Line 68">
              <a:extLst>
                <a:ext uri="{FF2B5EF4-FFF2-40B4-BE49-F238E27FC236}">
                  <a16:creationId xmlns:a16="http://schemas.microsoft.com/office/drawing/2014/main" id="{5564A188-D835-2045-A330-4BAB67366F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893248" y="1893811"/>
              <a:ext cx="0" cy="315913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Line 69">
              <a:extLst>
                <a:ext uri="{FF2B5EF4-FFF2-40B4-BE49-F238E27FC236}">
                  <a16:creationId xmlns:a16="http://schemas.microsoft.com/office/drawing/2014/main" id="{6439202E-B642-154D-982F-C6B9B22E1B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21798" y="204303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Line 70">
              <a:extLst>
                <a:ext uri="{FF2B5EF4-FFF2-40B4-BE49-F238E27FC236}">
                  <a16:creationId xmlns:a16="http://schemas.microsoft.com/office/drawing/2014/main" id="{D2211869-DCD9-A644-BBF5-A428346E31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21798" y="246848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Line 71">
              <a:extLst>
                <a:ext uri="{FF2B5EF4-FFF2-40B4-BE49-F238E27FC236}">
                  <a16:creationId xmlns:a16="http://schemas.microsoft.com/office/drawing/2014/main" id="{B74E95EF-AFAF-E046-A7CC-F00F83D443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761485" y="2041448"/>
              <a:ext cx="0" cy="427038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Line 72">
              <a:extLst>
                <a:ext uri="{FF2B5EF4-FFF2-40B4-BE49-F238E27FC236}">
                  <a16:creationId xmlns:a16="http://schemas.microsoft.com/office/drawing/2014/main" id="{35F2435B-0EB4-DC47-BDFF-110065CF30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3685" y="188904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Line 73">
              <a:extLst>
                <a:ext uri="{FF2B5EF4-FFF2-40B4-BE49-F238E27FC236}">
                  <a16:creationId xmlns:a16="http://schemas.microsoft.com/office/drawing/2014/main" id="{75E70E5D-5EF3-C244-B35E-8F50FAABEDB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83685" y="229386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Line 74">
              <a:extLst>
                <a:ext uri="{FF2B5EF4-FFF2-40B4-BE49-F238E27FC236}">
                  <a16:creationId xmlns:a16="http://schemas.microsoft.com/office/drawing/2014/main" id="{789F4F4C-CF47-784C-A581-A5ED03007B4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23373" y="1887461"/>
              <a:ext cx="0" cy="40640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Line 75">
              <a:extLst>
                <a:ext uri="{FF2B5EF4-FFF2-40B4-BE49-F238E27FC236}">
                  <a16:creationId xmlns:a16="http://schemas.microsoft.com/office/drawing/2014/main" id="{5B2B35A7-FF78-2D41-8A13-06166B87E7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51923" y="199223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Line 76">
              <a:extLst>
                <a:ext uri="{FF2B5EF4-FFF2-40B4-BE49-F238E27FC236}">
                  <a16:creationId xmlns:a16="http://schemas.microsoft.com/office/drawing/2014/main" id="{56041345-58F1-0447-823B-3055A03DA9B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51923" y="2324023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Line 77">
              <a:extLst>
                <a:ext uri="{FF2B5EF4-FFF2-40B4-BE49-F238E27FC236}">
                  <a16:creationId xmlns:a16="http://schemas.microsoft.com/office/drawing/2014/main" id="{5F0878CA-2A35-6943-AD4C-07A9DEB20D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91610" y="1990648"/>
              <a:ext cx="0" cy="333375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Line 78">
              <a:extLst>
                <a:ext uri="{FF2B5EF4-FFF2-40B4-BE49-F238E27FC236}">
                  <a16:creationId xmlns:a16="http://schemas.microsoft.com/office/drawing/2014/main" id="{48CD3E91-31B3-4D4A-98B1-B3D7FD6414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16985" y="192714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Line 79">
              <a:extLst>
                <a:ext uri="{FF2B5EF4-FFF2-40B4-BE49-F238E27FC236}">
                  <a16:creationId xmlns:a16="http://schemas.microsoft.com/office/drawing/2014/main" id="{960B2616-CBD1-1841-8C27-6D04106B49E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16985" y="220654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Line 80">
              <a:extLst>
                <a:ext uri="{FF2B5EF4-FFF2-40B4-BE49-F238E27FC236}">
                  <a16:creationId xmlns:a16="http://schemas.microsoft.com/office/drawing/2014/main" id="{1E1C05F1-4E6B-404C-8526-4EEAB4118BB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56673" y="1925561"/>
              <a:ext cx="0" cy="280988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Line 81">
              <a:extLst>
                <a:ext uri="{FF2B5EF4-FFF2-40B4-BE49-F238E27FC236}">
                  <a16:creationId xmlns:a16="http://schemas.microsoft.com/office/drawing/2014/main" id="{1ACD6C49-9E5E-E244-8D9E-723A08F129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85223" y="2019223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Line 82">
              <a:extLst>
                <a:ext uri="{FF2B5EF4-FFF2-40B4-BE49-F238E27FC236}">
                  <a16:creationId xmlns:a16="http://schemas.microsoft.com/office/drawing/2014/main" id="{C98776D0-07EB-C948-8FE8-4B3F47C663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85223" y="230338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Line 83">
              <a:extLst>
                <a:ext uri="{FF2B5EF4-FFF2-40B4-BE49-F238E27FC236}">
                  <a16:creationId xmlns:a16="http://schemas.microsoft.com/office/drawing/2014/main" id="{9AE4B953-AD9E-EE4C-9B08-D0088677F4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24910" y="2017636"/>
              <a:ext cx="0" cy="28575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Line 84">
              <a:extLst>
                <a:ext uri="{FF2B5EF4-FFF2-40B4-BE49-F238E27FC236}">
                  <a16:creationId xmlns:a16="http://schemas.microsoft.com/office/drawing/2014/main" id="{5D2F7B66-AA71-F642-8B77-7049D477381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8698" y="203351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Line 85">
              <a:extLst>
                <a:ext uri="{FF2B5EF4-FFF2-40B4-BE49-F238E27FC236}">
                  <a16:creationId xmlns:a16="http://schemas.microsoft.com/office/drawing/2014/main" id="{36C2955C-506F-8244-A71E-B27355F52B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48698" y="2298623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Line 86">
              <a:extLst>
                <a:ext uri="{FF2B5EF4-FFF2-40B4-BE49-F238E27FC236}">
                  <a16:creationId xmlns:a16="http://schemas.microsoft.com/office/drawing/2014/main" id="{21E6792C-6427-B841-B8F7-E6F8DF5E565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88385" y="2031923"/>
              <a:ext cx="0" cy="26670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Line 87">
              <a:extLst>
                <a:ext uri="{FF2B5EF4-FFF2-40B4-BE49-F238E27FC236}">
                  <a16:creationId xmlns:a16="http://schemas.microsoft.com/office/drawing/2014/main" id="{E1A32149-4505-354B-8F93-D6916CCE45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15348" y="203033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Line 88">
              <a:extLst>
                <a:ext uri="{FF2B5EF4-FFF2-40B4-BE49-F238E27FC236}">
                  <a16:creationId xmlns:a16="http://schemas.microsoft.com/office/drawing/2014/main" id="{FFB5FC80-60E4-F347-99CC-90E8917D93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15348" y="229703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Line 89">
              <a:extLst>
                <a:ext uri="{FF2B5EF4-FFF2-40B4-BE49-F238E27FC236}">
                  <a16:creationId xmlns:a16="http://schemas.microsoft.com/office/drawing/2014/main" id="{49F2EBDA-A81C-2F44-93D0-1074A5223F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55035" y="2030336"/>
              <a:ext cx="0" cy="26670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Line 90">
              <a:extLst>
                <a:ext uri="{FF2B5EF4-FFF2-40B4-BE49-F238E27FC236}">
                  <a16:creationId xmlns:a16="http://schemas.microsoft.com/office/drawing/2014/main" id="{8C36D2C7-A342-5042-9B9C-7A04DA98E8E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7060" y="216844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Line 91">
              <a:extLst>
                <a:ext uri="{FF2B5EF4-FFF2-40B4-BE49-F238E27FC236}">
                  <a16:creationId xmlns:a16="http://schemas.microsoft.com/office/drawing/2014/main" id="{B96757D8-E998-F842-A687-6B3C06A7DBB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7060" y="248594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Line 92">
              <a:extLst>
                <a:ext uri="{FF2B5EF4-FFF2-40B4-BE49-F238E27FC236}">
                  <a16:creationId xmlns:a16="http://schemas.microsoft.com/office/drawing/2014/main" id="{C5DB3FE6-9D57-3843-8DFE-1B2A1623EC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86748" y="2166861"/>
              <a:ext cx="0" cy="319088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Line 93">
              <a:extLst>
                <a:ext uri="{FF2B5EF4-FFF2-40B4-BE49-F238E27FC236}">
                  <a16:creationId xmlns:a16="http://schemas.microsoft.com/office/drawing/2014/main" id="{E2FDAA5A-FC39-1D47-8218-77E519AD3D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2123" y="212876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Line 94">
              <a:extLst>
                <a:ext uri="{FF2B5EF4-FFF2-40B4-BE49-F238E27FC236}">
                  <a16:creationId xmlns:a16="http://schemas.microsoft.com/office/drawing/2014/main" id="{AA9562D2-3965-5341-99E0-81388C29F0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2123" y="243673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Line 95">
              <a:extLst>
                <a:ext uri="{FF2B5EF4-FFF2-40B4-BE49-F238E27FC236}">
                  <a16:creationId xmlns:a16="http://schemas.microsoft.com/office/drawing/2014/main" id="{DE379A15-AEDC-DC44-AAF0-2E394C9B9B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1810" y="2127173"/>
              <a:ext cx="0" cy="309563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Line 96">
              <a:extLst>
                <a:ext uri="{FF2B5EF4-FFF2-40B4-BE49-F238E27FC236}">
                  <a16:creationId xmlns:a16="http://schemas.microsoft.com/office/drawing/2014/main" id="{51D65456-1E74-6044-AEF3-4295ABDEE1D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5598" y="2108123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Line 97">
              <a:extLst>
                <a:ext uri="{FF2B5EF4-FFF2-40B4-BE49-F238E27FC236}">
                  <a16:creationId xmlns:a16="http://schemas.microsoft.com/office/drawing/2014/main" id="{B6AAE305-7133-1540-B1DE-7D792FC1E6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5598" y="2411336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Line 98">
              <a:extLst>
                <a:ext uri="{FF2B5EF4-FFF2-40B4-BE49-F238E27FC236}">
                  <a16:creationId xmlns:a16="http://schemas.microsoft.com/office/drawing/2014/main" id="{5B235EE5-D588-9C49-85BA-F021B13C5E2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5285" y="2106536"/>
              <a:ext cx="0" cy="30480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Line 99">
              <a:extLst>
                <a:ext uri="{FF2B5EF4-FFF2-40B4-BE49-F238E27FC236}">
                  <a16:creationId xmlns:a16="http://schemas.microsoft.com/office/drawing/2014/main" id="{F9479337-FB35-3842-A47B-870DB3FC7C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0410" y="2109711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Line 100">
              <a:extLst>
                <a:ext uri="{FF2B5EF4-FFF2-40B4-BE49-F238E27FC236}">
                  <a16:creationId xmlns:a16="http://schemas.microsoft.com/office/drawing/2014/main" id="{56BBB6FC-E2C3-8242-941D-CCD969583A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0410" y="2435148"/>
              <a:ext cx="79375" cy="0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Line 101">
              <a:extLst>
                <a:ext uri="{FF2B5EF4-FFF2-40B4-BE49-F238E27FC236}">
                  <a16:creationId xmlns:a16="http://schemas.microsoft.com/office/drawing/2014/main" id="{7B517EB0-5F4C-4145-B5F3-C7E6004623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0098" y="2108122"/>
              <a:ext cx="0" cy="330555"/>
            </a:xfrm>
            <a:prstGeom prst="line">
              <a:avLst/>
            </a:prstGeom>
            <a:noFill/>
            <a:ln w="9525" cap="flat">
              <a:solidFill>
                <a:srgbClr val="E6000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0" name="Group 209">
            <a:extLst>
              <a:ext uri="{FF2B5EF4-FFF2-40B4-BE49-F238E27FC236}">
                <a16:creationId xmlns:a16="http://schemas.microsoft.com/office/drawing/2014/main" id="{EC174E88-1DCE-F543-AF68-1D10DB4CBA9E}"/>
              </a:ext>
            </a:extLst>
          </p:cNvPr>
          <p:cNvGrpSpPr/>
          <p:nvPr/>
        </p:nvGrpSpPr>
        <p:grpSpPr>
          <a:xfrm>
            <a:off x="2774905" y="2271241"/>
            <a:ext cx="5715000" cy="985837"/>
            <a:chOff x="6265863" y="2616201"/>
            <a:chExt cx="5715000" cy="985837"/>
          </a:xfrm>
          <a:solidFill>
            <a:srgbClr val="E60004"/>
          </a:solidFill>
        </p:grpSpPr>
        <p:sp>
          <p:nvSpPr>
            <p:cNvPr id="211" name="Oval 5">
              <a:extLst>
                <a:ext uri="{FF2B5EF4-FFF2-40B4-BE49-F238E27FC236}">
                  <a16:creationId xmlns:a16="http://schemas.microsoft.com/office/drawing/2014/main" id="{890EB945-311E-8448-85A6-3076168F8E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65863" y="3114676"/>
              <a:ext cx="73025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Oval 6">
              <a:extLst>
                <a:ext uri="{FF2B5EF4-FFF2-40B4-BE49-F238E27FC236}">
                  <a16:creationId xmlns:a16="http://schemas.microsoft.com/office/drawing/2014/main" id="{E224D19B-9F32-0F46-91C1-5ECA666750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9213" y="3141663"/>
              <a:ext cx="73025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Oval 7">
              <a:extLst>
                <a:ext uri="{FF2B5EF4-FFF2-40B4-BE49-F238E27FC236}">
                  <a16:creationId xmlns:a16="http://schemas.microsoft.com/office/drawing/2014/main" id="{8A2301FF-2376-6C42-BCE1-9498318356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32563" y="3182938"/>
              <a:ext cx="73025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Oval 8">
              <a:extLst>
                <a:ext uri="{FF2B5EF4-FFF2-40B4-BE49-F238E27FC236}">
                  <a16:creationId xmlns:a16="http://schemas.microsoft.com/office/drawing/2014/main" id="{10CC5CEA-FFEC-B94C-904D-050B205613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69088" y="3130551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Oval 9">
              <a:extLst>
                <a:ext uri="{FF2B5EF4-FFF2-40B4-BE49-F238E27FC236}">
                  <a16:creationId xmlns:a16="http://schemas.microsoft.com/office/drawing/2014/main" id="{193A937F-1DCF-8845-AFDA-363C9E4DA2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00850" y="3017838"/>
              <a:ext cx="73025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Oval 10">
              <a:extLst>
                <a:ext uri="{FF2B5EF4-FFF2-40B4-BE49-F238E27FC236}">
                  <a16:creationId xmlns:a16="http://schemas.microsoft.com/office/drawing/2014/main" id="{8D8A4A84-BE17-294D-A82B-050B4C3132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38963" y="3022601"/>
              <a:ext cx="71438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Oval 11">
              <a:extLst>
                <a:ext uri="{FF2B5EF4-FFF2-40B4-BE49-F238E27FC236}">
                  <a16:creationId xmlns:a16="http://schemas.microsoft.com/office/drawing/2014/main" id="{F4DF62D6-7B42-B74B-A8AE-8E27895843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69138" y="3022601"/>
              <a:ext cx="73025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Oval 12">
              <a:extLst>
                <a:ext uri="{FF2B5EF4-FFF2-40B4-BE49-F238E27FC236}">
                  <a16:creationId xmlns:a16="http://schemas.microsoft.com/office/drawing/2014/main" id="{54199F9A-2CEB-0C42-947A-30795FD01F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04075" y="2925763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Oval 13">
              <a:extLst>
                <a:ext uri="{FF2B5EF4-FFF2-40B4-BE49-F238E27FC236}">
                  <a16:creationId xmlns:a16="http://schemas.microsoft.com/office/drawing/2014/main" id="{35045755-1DED-274D-9424-1DB62971AC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40600" y="3014663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Oval 14">
              <a:extLst>
                <a:ext uri="{FF2B5EF4-FFF2-40B4-BE49-F238E27FC236}">
                  <a16:creationId xmlns:a16="http://schemas.microsoft.com/office/drawing/2014/main" id="{60A150AD-C4A6-044A-8F92-E634BF648D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73950" y="2951163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Oval 15">
              <a:extLst>
                <a:ext uri="{FF2B5EF4-FFF2-40B4-BE49-F238E27FC236}">
                  <a16:creationId xmlns:a16="http://schemas.microsoft.com/office/drawing/2014/main" id="{1EAA1B96-950C-0C44-9E4D-B28E36FE79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08888" y="3113088"/>
              <a:ext cx="73025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Oval 16">
              <a:extLst>
                <a:ext uri="{FF2B5EF4-FFF2-40B4-BE49-F238E27FC236}">
                  <a16:creationId xmlns:a16="http://schemas.microsoft.com/office/drawing/2014/main" id="{CEEF6749-A161-3142-ABBC-39234D173E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43825" y="2916238"/>
              <a:ext cx="73025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Oval 17">
              <a:extLst>
                <a:ext uri="{FF2B5EF4-FFF2-40B4-BE49-F238E27FC236}">
                  <a16:creationId xmlns:a16="http://schemas.microsoft.com/office/drawing/2014/main" id="{FE9D1FA1-4109-F640-BB48-DF60503B56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75588" y="2933701"/>
              <a:ext cx="73025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Oval 18">
              <a:extLst>
                <a:ext uri="{FF2B5EF4-FFF2-40B4-BE49-F238E27FC236}">
                  <a16:creationId xmlns:a16="http://schemas.microsoft.com/office/drawing/2014/main" id="{61F5293E-016D-EA49-9078-5E235A55ED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12113" y="2844801"/>
              <a:ext cx="71438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Oval 19">
              <a:extLst>
                <a:ext uri="{FF2B5EF4-FFF2-40B4-BE49-F238E27FC236}">
                  <a16:creationId xmlns:a16="http://schemas.microsoft.com/office/drawing/2014/main" id="{1845F526-39BB-D949-92D2-C070A262ED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47050" y="3027363"/>
              <a:ext cx="73025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Oval 20">
              <a:extLst>
                <a:ext uri="{FF2B5EF4-FFF2-40B4-BE49-F238E27FC236}">
                  <a16:creationId xmlns:a16="http://schemas.microsoft.com/office/drawing/2014/main" id="{B60745C9-7061-8149-AFCB-85DD935436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80400" y="3028951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7" name="Oval 21">
              <a:extLst>
                <a:ext uri="{FF2B5EF4-FFF2-40B4-BE49-F238E27FC236}">
                  <a16:creationId xmlns:a16="http://schemas.microsoft.com/office/drawing/2014/main" id="{4075C7E4-AEE2-A04B-BDB0-F839FDA3CD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15338" y="2970213"/>
              <a:ext cx="71438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Oval 22">
              <a:extLst>
                <a:ext uri="{FF2B5EF4-FFF2-40B4-BE49-F238E27FC236}">
                  <a16:creationId xmlns:a16="http://schemas.microsoft.com/office/drawing/2014/main" id="{B409722D-C28A-A147-AA78-1DC1B2D390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48688" y="2805113"/>
              <a:ext cx="73025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Oval 23">
              <a:extLst>
                <a:ext uri="{FF2B5EF4-FFF2-40B4-BE49-F238E27FC236}">
                  <a16:creationId xmlns:a16="http://schemas.microsoft.com/office/drawing/2014/main" id="{97BD27E7-45AE-0D49-B445-94D885C3B8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82038" y="2884488"/>
              <a:ext cx="73025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Oval 24">
              <a:extLst>
                <a:ext uri="{FF2B5EF4-FFF2-40B4-BE49-F238E27FC236}">
                  <a16:creationId xmlns:a16="http://schemas.microsoft.com/office/drawing/2014/main" id="{F13D511D-1E4C-7549-86F2-998465A147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16975" y="2908301"/>
              <a:ext cx="71438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Oval 25">
              <a:extLst>
                <a:ext uri="{FF2B5EF4-FFF2-40B4-BE49-F238E27FC236}">
                  <a16:creationId xmlns:a16="http://schemas.microsoft.com/office/drawing/2014/main" id="{A7158097-807E-8E4C-88D6-953FAC0202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951913" y="2971801"/>
              <a:ext cx="73025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Oval 26">
              <a:extLst>
                <a:ext uri="{FF2B5EF4-FFF2-40B4-BE49-F238E27FC236}">
                  <a16:creationId xmlns:a16="http://schemas.microsoft.com/office/drawing/2014/main" id="{9CF3CAAF-0FFB-9249-AA85-34179705C7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86850" y="3044826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Oval 27">
              <a:extLst>
                <a:ext uri="{FF2B5EF4-FFF2-40B4-BE49-F238E27FC236}">
                  <a16:creationId xmlns:a16="http://schemas.microsoft.com/office/drawing/2014/main" id="{790C9800-7FC7-0649-8345-0A7D348053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18613" y="3086101"/>
              <a:ext cx="73025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Oval 28">
              <a:extLst>
                <a:ext uri="{FF2B5EF4-FFF2-40B4-BE49-F238E27FC236}">
                  <a16:creationId xmlns:a16="http://schemas.microsoft.com/office/drawing/2014/main" id="{5D45F6E4-BFBD-3E49-B4A7-09B6D8C022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355138" y="3025776"/>
              <a:ext cx="73025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Oval 29">
              <a:extLst>
                <a:ext uri="{FF2B5EF4-FFF2-40B4-BE49-F238E27FC236}">
                  <a16:creationId xmlns:a16="http://schemas.microsoft.com/office/drawing/2014/main" id="{F65805DA-0668-3748-BB11-C1A58D6AE6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90075" y="3014663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Oval 30">
              <a:extLst>
                <a:ext uri="{FF2B5EF4-FFF2-40B4-BE49-F238E27FC236}">
                  <a16:creationId xmlns:a16="http://schemas.microsoft.com/office/drawing/2014/main" id="{D8FB0A87-A595-4340-A0D3-4688024EF7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23425" y="3173413"/>
              <a:ext cx="73025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Oval 31">
              <a:extLst>
                <a:ext uri="{FF2B5EF4-FFF2-40B4-BE49-F238E27FC236}">
                  <a16:creationId xmlns:a16="http://schemas.microsoft.com/office/drawing/2014/main" id="{0576CDDA-463B-7E4F-9A09-D6914DB5A7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759950" y="3071813"/>
              <a:ext cx="71438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8" name="Oval 32">
              <a:extLst>
                <a:ext uri="{FF2B5EF4-FFF2-40B4-BE49-F238E27FC236}">
                  <a16:creationId xmlns:a16="http://schemas.microsoft.com/office/drawing/2014/main" id="{3A8792C8-2D3B-D744-9273-17009CE182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93300" y="2981326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Oval 33">
              <a:extLst>
                <a:ext uri="{FF2B5EF4-FFF2-40B4-BE49-F238E27FC236}">
                  <a16:creationId xmlns:a16="http://schemas.microsoft.com/office/drawing/2014/main" id="{CA60B4ED-9B55-774A-A3BD-17A961AA9C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25063" y="2946401"/>
              <a:ext cx="71438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Oval 34">
              <a:extLst>
                <a:ext uri="{FF2B5EF4-FFF2-40B4-BE49-F238E27FC236}">
                  <a16:creationId xmlns:a16="http://schemas.microsoft.com/office/drawing/2014/main" id="{75E14F99-9A27-E749-8749-92E60911DE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158413" y="3067051"/>
              <a:ext cx="73025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Oval 35">
              <a:extLst>
                <a:ext uri="{FF2B5EF4-FFF2-40B4-BE49-F238E27FC236}">
                  <a16:creationId xmlns:a16="http://schemas.microsoft.com/office/drawing/2014/main" id="{746B72DA-4FFC-2948-90FA-F1F8515B7D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93350" y="3028951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Oval 36">
              <a:extLst>
                <a:ext uri="{FF2B5EF4-FFF2-40B4-BE49-F238E27FC236}">
                  <a16:creationId xmlns:a16="http://schemas.microsoft.com/office/drawing/2014/main" id="{950F18E3-6C0B-AC4B-8AE8-76AE673C14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431463" y="3527426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Oval 37">
              <a:extLst>
                <a:ext uri="{FF2B5EF4-FFF2-40B4-BE49-F238E27FC236}">
                  <a16:creationId xmlns:a16="http://schemas.microsoft.com/office/drawing/2014/main" id="{AA4830C7-E3EF-E84C-BDE6-397B65F70A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99750" y="2616201"/>
              <a:ext cx="71438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Oval 38">
              <a:extLst>
                <a:ext uri="{FF2B5EF4-FFF2-40B4-BE49-F238E27FC236}">
                  <a16:creationId xmlns:a16="http://schemas.microsoft.com/office/drawing/2014/main" id="{73750FD5-EFE0-FE41-9DD1-790D5653AC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33100" y="2616201"/>
              <a:ext cx="73025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Oval 39">
              <a:extLst>
                <a:ext uri="{FF2B5EF4-FFF2-40B4-BE49-F238E27FC236}">
                  <a16:creationId xmlns:a16="http://schemas.microsoft.com/office/drawing/2014/main" id="{10553D06-8DCF-B94D-AC93-52A0E1C48D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74488" y="3313113"/>
              <a:ext cx="71438" cy="71438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Oval 40">
              <a:extLst>
                <a:ext uri="{FF2B5EF4-FFF2-40B4-BE49-F238E27FC236}">
                  <a16:creationId xmlns:a16="http://schemas.microsoft.com/office/drawing/2014/main" id="{764803D9-FC35-934F-99B1-BC772EFF96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09425" y="3529013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7" name="Group 246">
            <a:extLst>
              <a:ext uri="{FF2B5EF4-FFF2-40B4-BE49-F238E27FC236}">
                <a16:creationId xmlns:a16="http://schemas.microsoft.com/office/drawing/2014/main" id="{D10022BC-8D99-1243-9071-FF9EF4ED9FD5}"/>
              </a:ext>
            </a:extLst>
          </p:cNvPr>
          <p:cNvGrpSpPr/>
          <p:nvPr/>
        </p:nvGrpSpPr>
        <p:grpSpPr>
          <a:xfrm>
            <a:off x="2767174" y="2089784"/>
            <a:ext cx="5592763" cy="1590675"/>
            <a:chOff x="246062" y="1397001"/>
            <a:chExt cx="5592763" cy="1590675"/>
          </a:xfrm>
        </p:grpSpPr>
        <p:sp>
          <p:nvSpPr>
            <p:cNvPr id="248" name="Freeform 5">
              <a:extLst>
                <a:ext uri="{FF2B5EF4-FFF2-40B4-BE49-F238E27FC236}">
                  <a16:creationId xmlns:a16="http://schemas.microsoft.com/office/drawing/2014/main" id="{DB8770EA-AA5F-8645-AAA5-DEBC931F7699}"/>
                </a:ext>
              </a:extLst>
            </p:cNvPr>
            <p:cNvSpPr>
              <a:spLocks/>
            </p:cNvSpPr>
            <p:nvPr/>
          </p:nvSpPr>
          <p:spPr bwMode="auto">
            <a:xfrm>
              <a:off x="290512" y="1612901"/>
              <a:ext cx="5372100" cy="1374775"/>
            </a:xfrm>
            <a:custGeom>
              <a:avLst/>
              <a:gdLst>
                <a:gd name="T0" fmla="*/ 0 w 7052"/>
                <a:gd name="T1" fmla="*/ 819 h 1803"/>
                <a:gd name="T2" fmla="*/ 175 w 7052"/>
                <a:gd name="T3" fmla="*/ 860 h 1803"/>
                <a:gd name="T4" fmla="*/ 353 w 7052"/>
                <a:gd name="T5" fmla="*/ 646 h 1803"/>
                <a:gd name="T6" fmla="*/ 529 w 7052"/>
                <a:gd name="T7" fmla="*/ 634 h 1803"/>
                <a:gd name="T8" fmla="*/ 703 w 7052"/>
                <a:gd name="T9" fmla="*/ 597 h 1803"/>
                <a:gd name="T10" fmla="*/ 879 w 7052"/>
                <a:gd name="T11" fmla="*/ 621 h 1803"/>
                <a:gd name="T12" fmla="*/ 1057 w 7052"/>
                <a:gd name="T13" fmla="*/ 469 h 1803"/>
                <a:gd name="T14" fmla="*/ 1230 w 7052"/>
                <a:gd name="T15" fmla="*/ 487 h 1803"/>
                <a:gd name="T16" fmla="*/ 1410 w 7052"/>
                <a:gd name="T17" fmla="*/ 649 h 1803"/>
                <a:gd name="T18" fmla="*/ 1584 w 7052"/>
                <a:gd name="T19" fmla="*/ 611 h 1803"/>
                <a:gd name="T20" fmla="*/ 1762 w 7052"/>
                <a:gd name="T21" fmla="*/ 503 h 1803"/>
                <a:gd name="T22" fmla="*/ 1940 w 7052"/>
                <a:gd name="T23" fmla="*/ 566 h 1803"/>
                <a:gd name="T24" fmla="*/ 2113 w 7052"/>
                <a:gd name="T25" fmla="*/ 595 h 1803"/>
                <a:gd name="T26" fmla="*/ 2290 w 7052"/>
                <a:gd name="T27" fmla="*/ 552 h 1803"/>
                <a:gd name="T28" fmla="*/ 2466 w 7052"/>
                <a:gd name="T29" fmla="*/ 750 h 1803"/>
                <a:gd name="T30" fmla="*/ 2645 w 7052"/>
                <a:gd name="T31" fmla="*/ 650 h 1803"/>
                <a:gd name="T32" fmla="*/ 2820 w 7052"/>
                <a:gd name="T33" fmla="*/ 527 h 1803"/>
                <a:gd name="T34" fmla="*/ 2995 w 7052"/>
                <a:gd name="T35" fmla="*/ 516 h 1803"/>
                <a:gd name="T36" fmla="*/ 3174 w 7052"/>
                <a:gd name="T37" fmla="*/ 803 h 1803"/>
                <a:gd name="T38" fmla="*/ 3353 w 7052"/>
                <a:gd name="T39" fmla="*/ 748 h 1803"/>
                <a:gd name="T40" fmla="*/ 3524 w 7052"/>
                <a:gd name="T41" fmla="*/ 698 h 1803"/>
                <a:gd name="T42" fmla="*/ 3703 w 7052"/>
                <a:gd name="T43" fmla="*/ 687 h 1803"/>
                <a:gd name="T44" fmla="*/ 3877 w 7052"/>
                <a:gd name="T45" fmla="*/ 798 h 1803"/>
                <a:gd name="T46" fmla="*/ 4055 w 7052"/>
                <a:gd name="T47" fmla="*/ 699 h 1803"/>
                <a:gd name="T48" fmla="*/ 4229 w 7052"/>
                <a:gd name="T49" fmla="*/ 600 h 1803"/>
                <a:gd name="T50" fmla="*/ 4408 w 7052"/>
                <a:gd name="T51" fmla="*/ 427 h 1803"/>
                <a:gd name="T52" fmla="*/ 4582 w 7052"/>
                <a:gd name="T53" fmla="*/ 554 h 1803"/>
                <a:gd name="T54" fmla="*/ 4759 w 7052"/>
                <a:gd name="T55" fmla="*/ 403 h 1803"/>
                <a:gd name="T56" fmla="*/ 4936 w 7052"/>
                <a:gd name="T57" fmla="*/ 976 h 1803"/>
                <a:gd name="T58" fmla="*/ 5114 w 7052"/>
                <a:gd name="T59" fmla="*/ 499 h 1803"/>
                <a:gd name="T60" fmla="*/ 5289 w 7052"/>
                <a:gd name="T61" fmla="*/ 907 h 1803"/>
                <a:gd name="T62" fmla="*/ 5465 w 7052"/>
                <a:gd name="T63" fmla="*/ 503 h 1803"/>
                <a:gd name="T64" fmla="*/ 5645 w 7052"/>
                <a:gd name="T65" fmla="*/ 598 h 1803"/>
                <a:gd name="T66" fmla="*/ 5819 w 7052"/>
                <a:gd name="T67" fmla="*/ 299 h 1803"/>
                <a:gd name="T68" fmla="*/ 5996 w 7052"/>
                <a:gd name="T69" fmla="*/ 605 h 1803"/>
                <a:gd name="T70" fmla="*/ 6168 w 7052"/>
                <a:gd name="T71" fmla="*/ 0 h 1803"/>
                <a:gd name="T72" fmla="*/ 6346 w 7052"/>
                <a:gd name="T73" fmla="*/ 1 h 1803"/>
                <a:gd name="T74" fmla="*/ 6522 w 7052"/>
                <a:gd name="T75" fmla="*/ 598 h 1803"/>
                <a:gd name="T76" fmla="*/ 6701 w 7052"/>
                <a:gd name="T77" fmla="*/ 0 h 1803"/>
                <a:gd name="T78" fmla="*/ 6876 w 7052"/>
                <a:gd name="T79" fmla="*/ 1197 h 1803"/>
                <a:gd name="T80" fmla="*/ 7052 w 7052"/>
                <a:gd name="T81" fmla="*/ 1803 h 1803"/>
                <a:gd name="connsiteX0" fmla="*/ 0 w 10000"/>
                <a:gd name="connsiteY0" fmla="*/ 4542 h 10000"/>
                <a:gd name="connsiteX1" fmla="*/ 248 w 10000"/>
                <a:gd name="connsiteY1" fmla="*/ 4770 h 10000"/>
                <a:gd name="connsiteX2" fmla="*/ 501 w 10000"/>
                <a:gd name="connsiteY2" fmla="*/ 3583 h 10000"/>
                <a:gd name="connsiteX3" fmla="*/ 750 w 10000"/>
                <a:gd name="connsiteY3" fmla="*/ 3516 h 10000"/>
                <a:gd name="connsiteX4" fmla="*/ 997 w 10000"/>
                <a:gd name="connsiteY4" fmla="*/ 3311 h 10000"/>
                <a:gd name="connsiteX5" fmla="*/ 1246 w 10000"/>
                <a:gd name="connsiteY5" fmla="*/ 3444 h 10000"/>
                <a:gd name="connsiteX6" fmla="*/ 1499 w 10000"/>
                <a:gd name="connsiteY6" fmla="*/ 2601 h 10000"/>
                <a:gd name="connsiteX7" fmla="*/ 1744 w 10000"/>
                <a:gd name="connsiteY7" fmla="*/ 2701 h 10000"/>
                <a:gd name="connsiteX8" fmla="*/ 1999 w 10000"/>
                <a:gd name="connsiteY8" fmla="*/ 3600 h 10000"/>
                <a:gd name="connsiteX9" fmla="*/ 2246 w 10000"/>
                <a:gd name="connsiteY9" fmla="*/ 3389 h 10000"/>
                <a:gd name="connsiteX10" fmla="*/ 2499 w 10000"/>
                <a:gd name="connsiteY10" fmla="*/ 2790 h 10000"/>
                <a:gd name="connsiteX11" fmla="*/ 2751 w 10000"/>
                <a:gd name="connsiteY11" fmla="*/ 3139 h 10000"/>
                <a:gd name="connsiteX12" fmla="*/ 2996 w 10000"/>
                <a:gd name="connsiteY12" fmla="*/ 3300 h 10000"/>
                <a:gd name="connsiteX13" fmla="*/ 3247 w 10000"/>
                <a:gd name="connsiteY13" fmla="*/ 3062 h 10000"/>
                <a:gd name="connsiteX14" fmla="*/ 3497 w 10000"/>
                <a:gd name="connsiteY14" fmla="*/ 4160 h 10000"/>
                <a:gd name="connsiteX15" fmla="*/ 3751 w 10000"/>
                <a:gd name="connsiteY15" fmla="*/ 3605 h 10000"/>
                <a:gd name="connsiteX16" fmla="*/ 3999 w 10000"/>
                <a:gd name="connsiteY16" fmla="*/ 2923 h 10000"/>
                <a:gd name="connsiteX17" fmla="*/ 4247 w 10000"/>
                <a:gd name="connsiteY17" fmla="*/ 2862 h 10000"/>
                <a:gd name="connsiteX18" fmla="*/ 4501 w 10000"/>
                <a:gd name="connsiteY18" fmla="*/ 4454 h 10000"/>
                <a:gd name="connsiteX19" fmla="*/ 4755 w 10000"/>
                <a:gd name="connsiteY19" fmla="*/ 4149 h 10000"/>
                <a:gd name="connsiteX20" fmla="*/ 4997 w 10000"/>
                <a:gd name="connsiteY20" fmla="*/ 3871 h 10000"/>
                <a:gd name="connsiteX21" fmla="*/ 5251 w 10000"/>
                <a:gd name="connsiteY21" fmla="*/ 3810 h 10000"/>
                <a:gd name="connsiteX22" fmla="*/ 5498 w 10000"/>
                <a:gd name="connsiteY22" fmla="*/ 4426 h 10000"/>
                <a:gd name="connsiteX23" fmla="*/ 5750 w 10000"/>
                <a:gd name="connsiteY23" fmla="*/ 3877 h 10000"/>
                <a:gd name="connsiteX24" fmla="*/ 5997 w 10000"/>
                <a:gd name="connsiteY24" fmla="*/ 3328 h 10000"/>
                <a:gd name="connsiteX25" fmla="*/ 6251 w 10000"/>
                <a:gd name="connsiteY25" fmla="*/ 2368 h 10000"/>
                <a:gd name="connsiteX26" fmla="*/ 6497 w 10000"/>
                <a:gd name="connsiteY26" fmla="*/ 3073 h 10000"/>
                <a:gd name="connsiteX27" fmla="*/ 6748 w 10000"/>
                <a:gd name="connsiteY27" fmla="*/ 2235 h 10000"/>
                <a:gd name="connsiteX28" fmla="*/ 6999 w 10000"/>
                <a:gd name="connsiteY28" fmla="*/ 5413 h 10000"/>
                <a:gd name="connsiteX29" fmla="*/ 7252 w 10000"/>
                <a:gd name="connsiteY29" fmla="*/ 2768 h 10000"/>
                <a:gd name="connsiteX30" fmla="*/ 7500 w 10000"/>
                <a:gd name="connsiteY30" fmla="*/ 5031 h 10000"/>
                <a:gd name="connsiteX31" fmla="*/ 7744 w 10000"/>
                <a:gd name="connsiteY31" fmla="*/ 3298 h 10000"/>
                <a:gd name="connsiteX32" fmla="*/ 8005 w 10000"/>
                <a:gd name="connsiteY32" fmla="*/ 3317 h 10000"/>
                <a:gd name="connsiteX33" fmla="*/ 8252 w 10000"/>
                <a:gd name="connsiteY33" fmla="*/ 1658 h 10000"/>
                <a:gd name="connsiteX34" fmla="*/ 8503 w 10000"/>
                <a:gd name="connsiteY34" fmla="*/ 3356 h 10000"/>
                <a:gd name="connsiteX35" fmla="*/ 8746 w 10000"/>
                <a:gd name="connsiteY35" fmla="*/ 0 h 10000"/>
                <a:gd name="connsiteX36" fmla="*/ 8999 w 10000"/>
                <a:gd name="connsiteY36" fmla="*/ 6 h 10000"/>
                <a:gd name="connsiteX37" fmla="*/ 9248 w 10000"/>
                <a:gd name="connsiteY37" fmla="*/ 3317 h 10000"/>
                <a:gd name="connsiteX38" fmla="*/ 9502 w 10000"/>
                <a:gd name="connsiteY38" fmla="*/ 0 h 10000"/>
                <a:gd name="connsiteX39" fmla="*/ 9750 w 10000"/>
                <a:gd name="connsiteY39" fmla="*/ 6639 h 10000"/>
                <a:gd name="connsiteX40" fmla="*/ 10000 w 10000"/>
                <a:gd name="connsiteY40" fmla="*/ 10000 h 10000"/>
                <a:gd name="connsiteX0" fmla="*/ 0 w 10000"/>
                <a:gd name="connsiteY0" fmla="*/ 4542 h 10000"/>
                <a:gd name="connsiteX1" fmla="*/ 248 w 10000"/>
                <a:gd name="connsiteY1" fmla="*/ 4770 h 10000"/>
                <a:gd name="connsiteX2" fmla="*/ 501 w 10000"/>
                <a:gd name="connsiteY2" fmla="*/ 3583 h 10000"/>
                <a:gd name="connsiteX3" fmla="*/ 750 w 10000"/>
                <a:gd name="connsiteY3" fmla="*/ 3516 h 10000"/>
                <a:gd name="connsiteX4" fmla="*/ 997 w 10000"/>
                <a:gd name="connsiteY4" fmla="*/ 3311 h 10000"/>
                <a:gd name="connsiteX5" fmla="*/ 1246 w 10000"/>
                <a:gd name="connsiteY5" fmla="*/ 3444 h 10000"/>
                <a:gd name="connsiteX6" fmla="*/ 1499 w 10000"/>
                <a:gd name="connsiteY6" fmla="*/ 2601 h 10000"/>
                <a:gd name="connsiteX7" fmla="*/ 1744 w 10000"/>
                <a:gd name="connsiteY7" fmla="*/ 2701 h 10000"/>
                <a:gd name="connsiteX8" fmla="*/ 1999 w 10000"/>
                <a:gd name="connsiteY8" fmla="*/ 3600 h 10000"/>
                <a:gd name="connsiteX9" fmla="*/ 2246 w 10000"/>
                <a:gd name="connsiteY9" fmla="*/ 3389 h 10000"/>
                <a:gd name="connsiteX10" fmla="*/ 2499 w 10000"/>
                <a:gd name="connsiteY10" fmla="*/ 2790 h 10000"/>
                <a:gd name="connsiteX11" fmla="*/ 2751 w 10000"/>
                <a:gd name="connsiteY11" fmla="*/ 3139 h 10000"/>
                <a:gd name="connsiteX12" fmla="*/ 2996 w 10000"/>
                <a:gd name="connsiteY12" fmla="*/ 3300 h 10000"/>
                <a:gd name="connsiteX13" fmla="*/ 3247 w 10000"/>
                <a:gd name="connsiteY13" fmla="*/ 3062 h 10000"/>
                <a:gd name="connsiteX14" fmla="*/ 3497 w 10000"/>
                <a:gd name="connsiteY14" fmla="*/ 4160 h 10000"/>
                <a:gd name="connsiteX15" fmla="*/ 3751 w 10000"/>
                <a:gd name="connsiteY15" fmla="*/ 3605 h 10000"/>
                <a:gd name="connsiteX16" fmla="*/ 3999 w 10000"/>
                <a:gd name="connsiteY16" fmla="*/ 2923 h 10000"/>
                <a:gd name="connsiteX17" fmla="*/ 4247 w 10000"/>
                <a:gd name="connsiteY17" fmla="*/ 2862 h 10000"/>
                <a:gd name="connsiteX18" fmla="*/ 4501 w 10000"/>
                <a:gd name="connsiteY18" fmla="*/ 4454 h 10000"/>
                <a:gd name="connsiteX19" fmla="*/ 4755 w 10000"/>
                <a:gd name="connsiteY19" fmla="*/ 4149 h 10000"/>
                <a:gd name="connsiteX20" fmla="*/ 4997 w 10000"/>
                <a:gd name="connsiteY20" fmla="*/ 3871 h 10000"/>
                <a:gd name="connsiteX21" fmla="*/ 5251 w 10000"/>
                <a:gd name="connsiteY21" fmla="*/ 3810 h 10000"/>
                <a:gd name="connsiteX22" fmla="*/ 5498 w 10000"/>
                <a:gd name="connsiteY22" fmla="*/ 4426 h 10000"/>
                <a:gd name="connsiteX23" fmla="*/ 5750 w 10000"/>
                <a:gd name="connsiteY23" fmla="*/ 3877 h 10000"/>
                <a:gd name="connsiteX24" fmla="*/ 5997 w 10000"/>
                <a:gd name="connsiteY24" fmla="*/ 3328 h 10000"/>
                <a:gd name="connsiteX25" fmla="*/ 6251 w 10000"/>
                <a:gd name="connsiteY25" fmla="*/ 2368 h 10000"/>
                <a:gd name="connsiteX26" fmla="*/ 6497 w 10000"/>
                <a:gd name="connsiteY26" fmla="*/ 3073 h 10000"/>
                <a:gd name="connsiteX27" fmla="*/ 6748 w 10000"/>
                <a:gd name="connsiteY27" fmla="*/ 2235 h 10000"/>
                <a:gd name="connsiteX28" fmla="*/ 6999 w 10000"/>
                <a:gd name="connsiteY28" fmla="*/ 5413 h 10000"/>
                <a:gd name="connsiteX29" fmla="*/ 7252 w 10000"/>
                <a:gd name="connsiteY29" fmla="*/ 2768 h 10000"/>
                <a:gd name="connsiteX30" fmla="*/ 7500 w 10000"/>
                <a:gd name="connsiteY30" fmla="*/ 5031 h 10000"/>
                <a:gd name="connsiteX31" fmla="*/ 7744 w 10000"/>
                <a:gd name="connsiteY31" fmla="*/ 3483 h 10000"/>
                <a:gd name="connsiteX32" fmla="*/ 8005 w 10000"/>
                <a:gd name="connsiteY32" fmla="*/ 3317 h 10000"/>
                <a:gd name="connsiteX33" fmla="*/ 8252 w 10000"/>
                <a:gd name="connsiteY33" fmla="*/ 1658 h 10000"/>
                <a:gd name="connsiteX34" fmla="*/ 8503 w 10000"/>
                <a:gd name="connsiteY34" fmla="*/ 3356 h 10000"/>
                <a:gd name="connsiteX35" fmla="*/ 8746 w 10000"/>
                <a:gd name="connsiteY35" fmla="*/ 0 h 10000"/>
                <a:gd name="connsiteX36" fmla="*/ 8999 w 10000"/>
                <a:gd name="connsiteY36" fmla="*/ 6 h 10000"/>
                <a:gd name="connsiteX37" fmla="*/ 9248 w 10000"/>
                <a:gd name="connsiteY37" fmla="*/ 3317 h 10000"/>
                <a:gd name="connsiteX38" fmla="*/ 9502 w 10000"/>
                <a:gd name="connsiteY38" fmla="*/ 0 h 10000"/>
                <a:gd name="connsiteX39" fmla="*/ 9750 w 10000"/>
                <a:gd name="connsiteY39" fmla="*/ 6639 h 10000"/>
                <a:gd name="connsiteX40" fmla="*/ 10000 w 10000"/>
                <a:gd name="connsiteY40" fmla="*/ 10000 h 10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</a:cxnLst>
              <a:rect l="l" t="t" r="r" b="b"/>
              <a:pathLst>
                <a:path w="10000" h="10000">
                  <a:moveTo>
                    <a:pt x="0" y="4542"/>
                  </a:moveTo>
                  <a:lnTo>
                    <a:pt x="248" y="4770"/>
                  </a:lnTo>
                  <a:cubicBezTo>
                    <a:pt x="332" y="4374"/>
                    <a:pt x="417" y="3979"/>
                    <a:pt x="501" y="3583"/>
                  </a:cubicBezTo>
                  <a:lnTo>
                    <a:pt x="750" y="3516"/>
                  </a:lnTo>
                  <a:lnTo>
                    <a:pt x="997" y="3311"/>
                  </a:lnTo>
                  <a:lnTo>
                    <a:pt x="1246" y="3444"/>
                  </a:lnTo>
                  <a:cubicBezTo>
                    <a:pt x="1330" y="3163"/>
                    <a:pt x="1415" y="2882"/>
                    <a:pt x="1499" y="2601"/>
                  </a:cubicBezTo>
                  <a:lnTo>
                    <a:pt x="1744" y="2701"/>
                  </a:lnTo>
                  <a:lnTo>
                    <a:pt x="1999" y="3600"/>
                  </a:lnTo>
                  <a:lnTo>
                    <a:pt x="2246" y="3389"/>
                  </a:lnTo>
                  <a:cubicBezTo>
                    <a:pt x="2330" y="3189"/>
                    <a:pt x="2415" y="2990"/>
                    <a:pt x="2499" y="2790"/>
                  </a:cubicBezTo>
                  <a:lnTo>
                    <a:pt x="2751" y="3139"/>
                  </a:lnTo>
                  <a:lnTo>
                    <a:pt x="2996" y="3300"/>
                  </a:lnTo>
                  <a:lnTo>
                    <a:pt x="3247" y="3062"/>
                  </a:lnTo>
                  <a:cubicBezTo>
                    <a:pt x="3330" y="3428"/>
                    <a:pt x="3414" y="3794"/>
                    <a:pt x="3497" y="4160"/>
                  </a:cubicBezTo>
                  <a:lnTo>
                    <a:pt x="3751" y="3605"/>
                  </a:lnTo>
                  <a:cubicBezTo>
                    <a:pt x="3834" y="3378"/>
                    <a:pt x="3916" y="3150"/>
                    <a:pt x="3999" y="2923"/>
                  </a:cubicBezTo>
                  <a:lnTo>
                    <a:pt x="4247" y="2862"/>
                  </a:lnTo>
                  <a:cubicBezTo>
                    <a:pt x="4332" y="3393"/>
                    <a:pt x="4416" y="3923"/>
                    <a:pt x="4501" y="4454"/>
                  </a:cubicBezTo>
                  <a:lnTo>
                    <a:pt x="4755" y="4149"/>
                  </a:lnTo>
                  <a:lnTo>
                    <a:pt x="4997" y="3871"/>
                  </a:lnTo>
                  <a:lnTo>
                    <a:pt x="5251" y="3810"/>
                  </a:lnTo>
                  <a:lnTo>
                    <a:pt x="5498" y="4426"/>
                  </a:lnTo>
                  <a:lnTo>
                    <a:pt x="5750" y="3877"/>
                  </a:lnTo>
                  <a:lnTo>
                    <a:pt x="5997" y="3328"/>
                  </a:lnTo>
                  <a:cubicBezTo>
                    <a:pt x="6082" y="3008"/>
                    <a:pt x="6166" y="2688"/>
                    <a:pt x="6251" y="2368"/>
                  </a:cubicBezTo>
                  <a:lnTo>
                    <a:pt x="6497" y="3073"/>
                  </a:lnTo>
                  <a:cubicBezTo>
                    <a:pt x="6581" y="2794"/>
                    <a:pt x="6664" y="2514"/>
                    <a:pt x="6748" y="2235"/>
                  </a:cubicBezTo>
                  <a:cubicBezTo>
                    <a:pt x="6832" y="3294"/>
                    <a:pt x="6915" y="4354"/>
                    <a:pt x="6999" y="5413"/>
                  </a:cubicBezTo>
                  <a:cubicBezTo>
                    <a:pt x="7083" y="4531"/>
                    <a:pt x="7168" y="3650"/>
                    <a:pt x="7252" y="2768"/>
                  </a:cubicBezTo>
                  <a:cubicBezTo>
                    <a:pt x="7335" y="3522"/>
                    <a:pt x="7417" y="4277"/>
                    <a:pt x="7500" y="5031"/>
                  </a:cubicBezTo>
                  <a:cubicBezTo>
                    <a:pt x="7581" y="4453"/>
                    <a:pt x="7663" y="4061"/>
                    <a:pt x="7744" y="3483"/>
                  </a:cubicBezTo>
                  <a:lnTo>
                    <a:pt x="8005" y="3317"/>
                  </a:lnTo>
                  <a:cubicBezTo>
                    <a:pt x="8087" y="2764"/>
                    <a:pt x="8170" y="2211"/>
                    <a:pt x="8252" y="1658"/>
                  </a:cubicBezTo>
                  <a:cubicBezTo>
                    <a:pt x="8336" y="2224"/>
                    <a:pt x="8419" y="2790"/>
                    <a:pt x="8503" y="3356"/>
                  </a:cubicBezTo>
                  <a:lnTo>
                    <a:pt x="8746" y="0"/>
                  </a:lnTo>
                  <a:lnTo>
                    <a:pt x="8999" y="6"/>
                  </a:lnTo>
                  <a:lnTo>
                    <a:pt x="9248" y="3317"/>
                  </a:lnTo>
                  <a:cubicBezTo>
                    <a:pt x="9333" y="2211"/>
                    <a:pt x="9417" y="1106"/>
                    <a:pt x="9502" y="0"/>
                  </a:cubicBezTo>
                  <a:cubicBezTo>
                    <a:pt x="9585" y="2213"/>
                    <a:pt x="9667" y="4426"/>
                    <a:pt x="9750" y="6639"/>
                  </a:cubicBezTo>
                  <a:cubicBezTo>
                    <a:pt x="9833" y="7759"/>
                    <a:pt x="9917" y="8880"/>
                    <a:pt x="10000" y="10000"/>
                  </a:cubicBezTo>
                </a:path>
              </a:pathLst>
            </a:custGeom>
            <a:noFill/>
            <a:ln w="19050" cap="flat">
              <a:solidFill>
                <a:schemeClr val="tx1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49" name="Group 248">
              <a:extLst>
                <a:ext uri="{FF2B5EF4-FFF2-40B4-BE49-F238E27FC236}">
                  <a16:creationId xmlns:a16="http://schemas.microsoft.com/office/drawing/2014/main" id="{D55FFFE0-07DB-6D41-864D-ABD9A6976DF4}"/>
                </a:ext>
              </a:extLst>
            </p:cNvPr>
            <p:cNvGrpSpPr/>
            <p:nvPr/>
          </p:nvGrpSpPr>
          <p:grpSpPr>
            <a:xfrm>
              <a:off x="246062" y="1397001"/>
              <a:ext cx="5592763" cy="1425575"/>
              <a:chOff x="246062" y="1397001"/>
              <a:chExt cx="5592763" cy="1425575"/>
            </a:xfrm>
          </p:grpSpPr>
          <p:sp>
            <p:nvSpPr>
              <p:cNvPr id="250" name="Line 6">
                <a:extLst>
                  <a:ext uri="{FF2B5EF4-FFF2-40B4-BE49-F238E27FC236}">
                    <a16:creationId xmlns:a16="http://schemas.microsoft.com/office/drawing/2014/main" id="{7B780FEC-B890-0E46-BB2B-ECA6293A75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6062" y="206692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Line 7">
                <a:extLst>
                  <a:ext uri="{FF2B5EF4-FFF2-40B4-BE49-F238E27FC236}">
                    <a16:creationId xmlns:a16="http://schemas.microsoft.com/office/drawing/2014/main" id="{06FDB302-F283-094E-BEC3-60BCBFE509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6062" y="240347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Line 8">
                <a:extLst>
                  <a:ext uri="{FF2B5EF4-FFF2-40B4-BE49-F238E27FC236}">
                    <a16:creationId xmlns:a16="http://schemas.microsoft.com/office/drawing/2014/main" id="{43E18CA2-2459-4646-826F-276FDBDA13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5750" y="2065338"/>
                <a:ext cx="0" cy="33813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Line 9">
                <a:extLst>
                  <a:ext uri="{FF2B5EF4-FFF2-40B4-BE49-F238E27FC236}">
                    <a16:creationId xmlns:a16="http://schemas.microsoft.com/office/drawing/2014/main" id="{0281189E-A307-7048-9C6A-5DD839E138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2587" y="209232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Line 10">
                <a:extLst>
                  <a:ext uri="{FF2B5EF4-FFF2-40B4-BE49-F238E27FC236}">
                    <a16:creationId xmlns:a16="http://schemas.microsoft.com/office/drawing/2014/main" id="{BAFECFDB-1CD8-2547-87B4-A510349013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2587" y="244316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Line 11">
                <a:extLst>
                  <a:ext uri="{FF2B5EF4-FFF2-40B4-BE49-F238E27FC236}">
                    <a16:creationId xmlns:a16="http://schemas.microsoft.com/office/drawing/2014/main" id="{A6A10B04-6B00-B644-96A2-7BD4412764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22275" y="2092326"/>
                <a:ext cx="0" cy="35083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Line 12">
                <a:extLst>
                  <a:ext uri="{FF2B5EF4-FFF2-40B4-BE49-F238E27FC236}">
                    <a16:creationId xmlns:a16="http://schemas.microsoft.com/office/drawing/2014/main" id="{1443907E-3DED-A44C-91BC-277AAFFF0B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7525" y="191611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Line 13">
                <a:extLst>
                  <a:ext uri="{FF2B5EF4-FFF2-40B4-BE49-F238E27FC236}">
                    <a16:creationId xmlns:a16="http://schemas.microsoft.com/office/drawing/2014/main" id="{1D8F2487-867B-9B4E-AC9E-167083F9D2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7525" y="229711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Line 14">
                <a:extLst>
                  <a:ext uri="{FF2B5EF4-FFF2-40B4-BE49-F238E27FC236}">
                    <a16:creationId xmlns:a16="http://schemas.microsoft.com/office/drawing/2014/main" id="{2DAD7937-A503-8047-817C-141B9FC445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57212" y="1914526"/>
                <a:ext cx="0" cy="38258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Line 15">
                <a:extLst>
                  <a:ext uri="{FF2B5EF4-FFF2-40B4-BE49-F238E27FC236}">
                    <a16:creationId xmlns:a16="http://schemas.microsoft.com/office/drawing/2014/main" id="{C8CECFF7-D832-ED49-B511-6754C8D24C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2462" y="190341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Line 16">
                <a:extLst>
                  <a:ext uri="{FF2B5EF4-FFF2-40B4-BE49-F238E27FC236}">
                    <a16:creationId xmlns:a16="http://schemas.microsoft.com/office/drawing/2014/main" id="{33C9690C-6D63-EF45-A21E-B4725E6D6F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2462" y="2292351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Line 17">
                <a:extLst>
                  <a:ext uri="{FF2B5EF4-FFF2-40B4-BE49-F238E27FC236}">
                    <a16:creationId xmlns:a16="http://schemas.microsoft.com/office/drawing/2014/main" id="{43CCA52B-029E-DD4A-A9F1-45CE41126A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92150" y="1901826"/>
                <a:ext cx="0" cy="390525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Line 18">
                <a:extLst>
                  <a:ext uri="{FF2B5EF4-FFF2-40B4-BE49-F238E27FC236}">
                    <a16:creationId xmlns:a16="http://schemas.microsoft.com/office/drawing/2014/main" id="{2255E01F-9503-AE4F-BA8E-84886EE14A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5812" y="187801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Line 19">
                <a:extLst>
                  <a:ext uri="{FF2B5EF4-FFF2-40B4-BE49-F238E27FC236}">
                    <a16:creationId xmlns:a16="http://schemas.microsoft.com/office/drawing/2014/main" id="{E1E8DB7B-E29F-B344-9384-28ED21E107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5812" y="225107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Line 20">
                <a:extLst>
                  <a:ext uri="{FF2B5EF4-FFF2-40B4-BE49-F238E27FC236}">
                    <a16:creationId xmlns:a16="http://schemas.microsoft.com/office/drawing/2014/main" id="{2038835C-DFFF-7540-A2EE-A1C025C4E8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25500" y="1876426"/>
                <a:ext cx="0" cy="37465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Line 21">
                <a:extLst>
                  <a:ext uri="{FF2B5EF4-FFF2-40B4-BE49-F238E27FC236}">
                    <a16:creationId xmlns:a16="http://schemas.microsoft.com/office/drawing/2014/main" id="{802D792C-0963-8344-8D54-1839BB222A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20750" y="189706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" name="Line 22">
                <a:extLst>
                  <a:ext uri="{FF2B5EF4-FFF2-40B4-BE49-F238E27FC236}">
                    <a16:creationId xmlns:a16="http://schemas.microsoft.com/office/drawing/2014/main" id="{34AC3F3F-193F-0E41-88F5-9FCF5B1CDE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20750" y="227806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Line 23">
                <a:extLst>
                  <a:ext uri="{FF2B5EF4-FFF2-40B4-BE49-F238E27FC236}">
                    <a16:creationId xmlns:a16="http://schemas.microsoft.com/office/drawing/2014/main" id="{5B62EC83-AC02-7D4D-A4EF-F3FB3CEBCC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60437" y="1895476"/>
                <a:ext cx="0" cy="38258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Line 24">
                <a:extLst>
                  <a:ext uri="{FF2B5EF4-FFF2-40B4-BE49-F238E27FC236}">
                    <a16:creationId xmlns:a16="http://schemas.microsoft.com/office/drawing/2014/main" id="{0C2BF404-5735-2D40-B28B-3DF37793B6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55687" y="1803401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Line 25">
                <a:extLst>
                  <a:ext uri="{FF2B5EF4-FFF2-40B4-BE49-F238E27FC236}">
                    <a16:creationId xmlns:a16="http://schemas.microsoft.com/office/drawing/2014/main" id="{334C129C-B983-4141-856C-ED9FB867C4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55687" y="2128838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Line 26">
                <a:extLst>
                  <a:ext uri="{FF2B5EF4-FFF2-40B4-BE49-F238E27FC236}">
                    <a16:creationId xmlns:a16="http://schemas.microsoft.com/office/drawing/2014/main" id="{E21BB185-F4C2-774D-A5E4-9D3D675001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095375" y="1801813"/>
                <a:ext cx="0" cy="328613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" name="Line 27">
                <a:extLst>
                  <a:ext uri="{FF2B5EF4-FFF2-40B4-BE49-F238E27FC236}">
                    <a16:creationId xmlns:a16="http://schemas.microsoft.com/office/drawing/2014/main" id="{4A3E7AA6-2258-5C40-B0CE-3FBE50F196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89037" y="1779588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Line 28">
                <a:extLst>
                  <a:ext uri="{FF2B5EF4-FFF2-40B4-BE49-F238E27FC236}">
                    <a16:creationId xmlns:a16="http://schemas.microsoft.com/office/drawing/2014/main" id="{7FECBD5D-0432-DB40-89B6-4458949BDA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89037" y="2192338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Line 29">
                <a:extLst>
                  <a:ext uri="{FF2B5EF4-FFF2-40B4-BE49-F238E27FC236}">
                    <a16:creationId xmlns:a16="http://schemas.microsoft.com/office/drawing/2014/main" id="{EAA86A41-2108-5847-A98F-B88E8963FF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228725" y="1778001"/>
                <a:ext cx="0" cy="41433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" name="Line 30">
                <a:extLst>
                  <a:ext uri="{FF2B5EF4-FFF2-40B4-BE49-F238E27FC236}">
                    <a16:creationId xmlns:a16="http://schemas.microsoft.com/office/drawing/2014/main" id="{5EFF8C13-09E6-224E-8DBB-58EC221AEC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23975" y="187642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Line 31">
                <a:extLst>
                  <a:ext uri="{FF2B5EF4-FFF2-40B4-BE49-F238E27FC236}">
                    <a16:creationId xmlns:a16="http://schemas.microsoft.com/office/drawing/2014/main" id="{97E59D25-B494-9C4E-9482-451E9924A0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23975" y="2338388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" name="Line 32">
                <a:extLst>
                  <a:ext uri="{FF2B5EF4-FFF2-40B4-BE49-F238E27FC236}">
                    <a16:creationId xmlns:a16="http://schemas.microsoft.com/office/drawing/2014/main" id="{A5C71E58-A19C-4048-9808-D416E69674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363662" y="1874838"/>
                <a:ext cx="0" cy="46513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Line 33">
                <a:extLst>
                  <a:ext uri="{FF2B5EF4-FFF2-40B4-BE49-F238E27FC236}">
                    <a16:creationId xmlns:a16="http://schemas.microsoft.com/office/drawing/2014/main" id="{8E24F064-E278-B04D-BB1A-EE4680B70F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7325" y="184467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" name="Line 34">
                <a:extLst>
                  <a:ext uri="{FF2B5EF4-FFF2-40B4-BE49-F238E27FC236}">
                    <a16:creationId xmlns:a16="http://schemas.microsoft.com/office/drawing/2014/main" id="{7597CA91-B10F-F94E-AEFD-19ED0C425B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7325" y="2306638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Line 35">
                <a:extLst>
                  <a:ext uri="{FF2B5EF4-FFF2-40B4-BE49-F238E27FC236}">
                    <a16:creationId xmlns:a16="http://schemas.microsoft.com/office/drawing/2014/main" id="{F42C6F5B-DFFF-D14F-9D57-9F59C393C7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497012" y="1843088"/>
                <a:ext cx="0" cy="46355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" name="Line 36">
                <a:extLst>
                  <a:ext uri="{FF2B5EF4-FFF2-40B4-BE49-F238E27FC236}">
                    <a16:creationId xmlns:a16="http://schemas.microsoft.com/office/drawing/2014/main" id="{02C5E58B-8508-0840-AD0D-E885E37DB5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262" y="1779588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" name="Line 37">
                <a:extLst>
                  <a:ext uri="{FF2B5EF4-FFF2-40B4-BE49-F238E27FC236}">
                    <a16:creationId xmlns:a16="http://schemas.microsoft.com/office/drawing/2014/main" id="{CC6808C4-5F0C-F244-A146-49AF4180FF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262" y="2203451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" name="Line 38">
                <a:extLst>
                  <a:ext uri="{FF2B5EF4-FFF2-40B4-BE49-F238E27FC236}">
                    <a16:creationId xmlns:a16="http://schemas.microsoft.com/office/drawing/2014/main" id="{8DA79E4C-D0C0-AD44-8365-BF6B1F49A4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631950" y="1778001"/>
                <a:ext cx="0" cy="42545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Line 39">
                <a:extLst>
                  <a:ext uri="{FF2B5EF4-FFF2-40B4-BE49-F238E27FC236}">
                    <a16:creationId xmlns:a16="http://schemas.microsoft.com/office/drawing/2014/main" id="{30FC77A5-51F9-A54B-9616-EFE90869BB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25612" y="1771651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" name="Line 40">
                <a:extLst>
                  <a:ext uri="{FF2B5EF4-FFF2-40B4-BE49-F238E27FC236}">
                    <a16:creationId xmlns:a16="http://schemas.microsoft.com/office/drawing/2014/main" id="{379D5CCF-B2C6-8946-907C-5E1CC54CE5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25612" y="232251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Line 41">
                <a:extLst>
                  <a:ext uri="{FF2B5EF4-FFF2-40B4-BE49-F238E27FC236}">
                    <a16:creationId xmlns:a16="http://schemas.microsoft.com/office/drawing/2014/main" id="{8CE8716E-325C-2C4F-BCBE-DFDB7CC37F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65300" y="1770063"/>
                <a:ext cx="0" cy="55245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" name="Line 42">
                <a:extLst>
                  <a:ext uri="{FF2B5EF4-FFF2-40B4-BE49-F238E27FC236}">
                    <a16:creationId xmlns:a16="http://schemas.microsoft.com/office/drawing/2014/main" id="{93432DCD-F46A-2C41-B37D-138A6555CE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62137" y="177641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" name="Line 43">
                <a:extLst>
                  <a:ext uri="{FF2B5EF4-FFF2-40B4-BE49-F238E27FC236}">
                    <a16:creationId xmlns:a16="http://schemas.microsoft.com/office/drawing/2014/main" id="{AAD30FA7-4EA8-2A44-8BB0-5A34FA26B2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62137" y="235426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" name="Line 44">
                <a:extLst>
                  <a:ext uri="{FF2B5EF4-FFF2-40B4-BE49-F238E27FC236}">
                    <a16:creationId xmlns:a16="http://schemas.microsoft.com/office/drawing/2014/main" id="{B16D33EA-BF12-D249-B1DB-5DA27EC16F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01825" y="1774826"/>
                <a:ext cx="0" cy="57943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" name="Line 45">
                <a:extLst>
                  <a:ext uri="{FF2B5EF4-FFF2-40B4-BE49-F238E27FC236}">
                    <a16:creationId xmlns:a16="http://schemas.microsoft.com/office/drawing/2014/main" id="{DAA510F6-2733-2E49-9D8D-C1BD3C5E26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95487" y="176847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Line 46">
                <a:extLst>
                  <a:ext uri="{FF2B5EF4-FFF2-40B4-BE49-F238E27FC236}">
                    <a16:creationId xmlns:a16="http://schemas.microsoft.com/office/drawing/2014/main" id="{4CAB79EC-6EB7-5D4E-9A04-762D3E2B59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95487" y="229076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Line 47">
                <a:extLst>
                  <a:ext uri="{FF2B5EF4-FFF2-40B4-BE49-F238E27FC236}">
                    <a16:creationId xmlns:a16="http://schemas.microsoft.com/office/drawing/2014/main" id="{57B77E2A-F201-D847-88FC-F1D6B137DF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035175" y="1766888"/>
                <a:ext cx="0" cy="523875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Line 48">
                <a:extLst>
                  <a:ext uri="{FF2B5EF4-FFF2-40B4-BE49-F238E27FC236}">
                    <a16:creationId xmlns:a16="http://schemas.microsoft.com/office/drawing/2014/main" id="{6E529BF5-998C-F44F-9976-EDE388758A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0425" y="186531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" name="Line 49">
                <a:extLst>
                  <a:ext uri="{FF2B5EF4-FFF2-40B4-BE49-F238E27FC236}">
                    <a16:creationId xmlns:a16="http://schemas.microsoft.com/office/drawing/2014/main" id="{BE2AEFDB-79D8-EE4B-813B-55B838881F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0425" y="2516188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" name="Line 50">
                <a:extLst>
                  <a:ext uri="{FF2B5EF4-FFF2-40B4-BE49-F238E27FC236}">
                    <a16:creationId xmlns:a16="http://schemas.microsoft.com/office/drawing/2014/main" id="{B5F875B3-3397-F147-A22E-AEB8E751E2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70112" y="1863726"/>
                <a:ext cx="0" cy="652463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" name="Line 51">
                <a:extLst>
                  <a:ext uri="{FF2B5EF4-FFF2-40B4-BE49-F238E27FC236}">
                    <a16:creationId xmlns:a16="http://schemas.microsoft.com/office/drawing/2014/main" id="{B980A592-8626-9B4F-A9D3-8AAF55D856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5362" y="181927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" name="Line 52">
                <a:extLst>
                  <a:ext uri="{FF2B5EF4-FFF2-40B4-BE49-F238E27FC236}">
                    <a16:creationId xmlns:a16="http://schemas.microsoft.com/office/drawing/2014/main" id="{2BC2BF5A-E6DE-CC4C-BBF3-0B8D602F188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5362" y="239871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Line 53">
                <a:extLst>
                  <a:ext uri="{FF2B5EF4-FFF2-40B4-BE49-F238E27FC236}">
                    <a16:creationId xmlns:a16="http://schemas.microsoft.com/office/drawing/2014/main" id="{2F99CA96-5DCD-ED4A-8893-FC29CDB1C6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05050" y="1817688"/>
                <a:ext cx="0" cy="581025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" name="Line 54">
                <a:extLst>
                  <a:ext uri="{FF2B5EF4-FFF2-40B4-BE49-F238E27FC236}">
                    <a16:creationId xmlns:a16="http://schemas.microsoft.com/office/drawing/2014/main" id="{18E85C3D-E93B-6343-B4F8-0D011E0103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8712" y="157321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" name="Line 55">
                <a:extLst>
                  <a:ext uri="{FF2B5EF4-FFF2-40B4-BE49-F238E27FC236}">
                    <a16:creationId xmlns:a16="http://schemas.microsoft.com/office/drawing/2014/main" id="{EE43ED83-FB2F-894D-A9E5-133E7EAA13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8712" y="244792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" name="Line 56">
                <a:extLst>
                  <a:ext uri="{FF2B5EF4-FFF2-40B4-BE49-F238E27FC236}">
                    <a16:creationId xmlns:a16="http://schemas.microsoft.com/office/drawing/2014/main" id="{2EE90A7B-33D2-0044-9F03-D169099EC7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38400" y="1571626"/>
                <a:ext cx="0" cy="87630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" name="Line 57">
                <a:extLst>
                  <a:ext uri="{FF2B5EF4-FFF2-40B4-BE49-F238E27FC236}">
                    <a16:creationId xmlns:a16="http://schemas.microsoft.com/office/drawing/2014/main" id="{3846E414-4577-4B40-9D7E-591DE8E747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3650" y="1612901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" name="Line 58">
                <a:extLst>
                  <a:ext uri="{FF2B5EF4-FFF2-40B4-BE49-F238E27FC236}">
                    <a16:creationId xmlns:a16="http://schemas.microsoft.com/office/drawing/2014/main" id="{ED5507F9-10F5-DD4A-9FA0-C12ED0A4C4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33650" y="240347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" name="Line 59">
                <a:extLst>
                  <a:ext uri="{FF2B5EF4-FFF2-40B4-BE49-F238E27FC236}">
                    <a16:creationId xmlns:a16="http://schemas.microsoft.com/office/drawing/2014/main" id="{ADBC8267-9BC2-6140-AE29-62B5E927BE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573337" y="1611313"/>
                <a:ext cx="0" cy="792163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4" name="Line 60">
                <a:extLst>
                  <a:ext uri="{FF2B5EF4-FFF2-40B4-BE49-F238E27FC236}">
                    <a16:creationId xmlns:a16="http://schemas.microsoft.com/office/drawing/2014/main" id="{C4EB52F8-07BF-8F4D-BCCA-EE923F06A2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8587" y="1784351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5" name="Line 61">
                <a:extLst>
                  <a:ext uri="{FF2B5EF4-FFF2-40B4-BE49-F238E27FC236}">
                    <a16:creationId xmlns:a16="http://schemas.microsoft.com/office/drawing/2014/main" id="{4FE428A9-90A8-4A47-8CCF-FF92143BE4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8587" y="2662238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6" name="Line 62">
                <a:extLst>
                  <a:ext uri="{FF2B5EF4-FFF2-40B4-BE49-F238E27FC236}">
                    <a16:creationId xmlns:a16="http://schemas.microsoft.com/office/drawing/2014/main" id="{2B577070-0755-8245-9DAA-A0BEBEABCD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708275" y="1782763"/>
                <a:ext cx="0" cy="881063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7" name="Line 63">
                <a:extLst>
                  <a:ext uri="{FF2B5EF4-FFF2-40B4-BE49-F238E27FC236}">
                    <a16:creationId xmlns:a16="http://schemas.microsoft.com/office/drawing/2014/main" id="{952F32E2-9A7F-B74E-AFCC-8EA5FB6F62E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03525" y="1708151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" name="Line 64">
                <a:extLst>
                  <a:ext uri="{FF2B5EF4-FFF2-40B4-BE49-F238E27FC236}">
                    <a16:creationId xmlns:a16="http://schemas.microsoft.com/office/drawing/2014/main" id="{7A4F4271-8C93-054C-B6E1-D0CE9B106D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03525" y="2655888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" name="Line 65">
                <a:extLst>
                  <a:ext uri="{FF2B5EF4-FFF2-40B4-BE49-F238E27FC236}">
                    <a16:creationId xmlns:a16="http://schemas.microsoft.com/office/drawing/2014/main" id="{58DAD87D-22EA-B64A-A4B5-6EB10A27A0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843212" y="1704976"/>
                <a:ext cx="0" cy="950913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" name="Line 66">
                <a:extLst>
                  <a:ext uri="{FF2B5EF4-FFF2-40B4-BE49-F238E27FC236}">
                    <a16:creationId xmlns:a16="http://schemas.microsoft.com/office/drawing/2014/main" id="{76482C8C-8F32-2548-8329-03B844E4BB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38462" y="170497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" name="Line 67">
                <a:extLst>
                  <a:ext uri="{FF2B5EF4-FFF2-40B4-BE49-F238E27FC236}">
                    <a16:creationId xmlns:a16="http://schemas.microsoft.com/office/drawing/2014/main" id="{CFCC166B-91E8-DB4F-B19D-7B4473A98E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38462" y="258286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2" name="Line 68">
                <a:extLst>
                  <a:ext uri="{FF2B5EF4-FFF2-40B4-BE49-F238E27FC236}">
                    <a16:creationId xmlns:a16="http://schemas.microsoft.com/office/drawing/2014/main" id="{E5BDCDC1-9ABC-7846-BC45-862F0E582B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978150" y="1703388"/>
                <a:ext cx="0" cy="879475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" name="Line 69">
                <a:extLst>
                  <a:ext uri="{FF2B5EF4-FFF2-40B4-BE49-F238E27FC236}">
                    <a16:creationId xmlns:a16="http://schemas.microsoft.com/office/drawing/2014/main" id="{F3CF704C-A493-A149-AEB1-FA83DF4212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71812" y="171132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" name="Line 70">
                <a:extLst>
                  <a:ext uri="{FF2B5EF4-FFF2-40B4-BE49-F238E27FC236}">
                    <a16:creationId xmlns:a16="http://schemas.microsoft.com/office/drawing/2014/main" id="{DCCBF832-AD0E-D443-BF9F-5FADB632C1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71812" y="2560638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" name="Line 71">
                <a:extLst>
                  <a:ext uri="{FF2B5EF4-FFF2-40B4-BE49-F238E27FC236}">
                    <a16:creationId xmlns:a16="http://schemas.microsoft.com/office/drawing/2014/main" id="{7358B40B-7EAC-584F-B65F-E7A4E6458E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111500" y="1709738"/>
                <a:ext cx="0" cy="85090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" name="Line 72">
                <a:extLst>
                  <a:ext uri="{FF2B5EF4-FFF2-40B4-BE49-F238E27FC236}">
                    <a16:creationId xmlns:a16="http://schemas.microsoft.com/office/drawing/2014/main" id="{457645BD-5855-CF45-BFFA-EA40F0616C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06750" y="1619251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7" name="Line 73">
                <a:extLst>
                  <a:ext uri="{FF2B5EF4-FFF2-40B4-BE49-F238E27FC236}">
                    <a16:creationId xmlns:a16="http://schemas.microsoft.com/office/drawing/2014/main" id="{4B7A461D-F140-014C-A272-E907FEC4FD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06750" y="282257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" name="Line 74">
                <a:extLst>
                  <a:ext uri="{FF2B5EF4-FFF2-40B4-BE49-F238E27FC236}">
                    <a16:creationId xmlns:a16="http://schemas.microsoft.com/office/drawing/2014/main" id="{6BD98790-EE63-3845-A14C-C9D7F495CF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46437" y="1616076"/>
                <a:ext cx="0" cy="120650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" name="Line 75">
                <a:extLst>
                  <a:ext uri="{FF2B5EF4-FFF2-40B4-BE49-F238E27FC236}">
                    <a16:creationId xmlns:a16="http://schemas.microsoft.com/office/drawing/2014/main" id="{3BCABB35-BB44-3541-974A-6ABC5D2F73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0100" y="1606551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" name="Line 76">
                <a:extLst>
                  <a:ext uri="{FF2B5EF4-FFF2-40B4-BE49-F238E27FC236}">
                    <a16:creationId xmlns:a16="http://schemas.microsoft.com/office/drawing/2014/main" id="{244A9965-4886-E84E-86AF-6D3FCF81DF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0100" y="2687638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" name="Line 77">
                <a:extLst>
                  <a:ext uri="{FF2B5EF4-FFF2-40B4-BE49-F238E27FC236}">
                    <a16:creationId xmlns:a16="http://schemas.microsoft.com/office/drawing/2014/main" id="{A5B2024C-BF12-BF48-9C95-58AF0E9444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379787" y="1603376"/>
                <a:ext cx="0" cy="1084263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" name="Line 78">
                <a:extLst>
                  <a:ext uri="{FF2B5EF4-FFF2-40B4-BE49-F238E27FC236}">
                    <a16:creationId xmlns:a16="http://schemas.microsoft.com/office/drawing/2014/main" id="{10331775-B092-8C48-8D13-1091016C2E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75037" y="1517651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" name="Line 79">
                <a:extLst>
                  <a:ext uri="{FF2B5EF4-FFF2-40B4-BE49-F238E27FC236}">
                    <a16:creationId xmlns:a16="http://schemas.microsoft.com/office/drawing/2014/main" id="{1E86451A-AF88-9146-AF89-6E45657A01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75037" y="2617788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" name="Line 80">
                <a:extLst>
                  <a:ext uri="{FF2B5EF4-FFF2-40B4-BE49-F238E27FC236}">
                    <a16:creationId xmlns:a16="http://schemas.microsoft.com/office/drawing/2014/main" id="{F7240E95-B519-E84E-A948-D08EA673C1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514725" y="1516063"/>
                <a:ext cx="0" cy="1101725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Line 81">
                <a:extLst>
                  <a:ext uri="{FF2B5EF4-FFF2-40B4-BE49-F238E27FC236}">
                    <a16:creationId xmlns:a16="http://schemas.microsoft.com/office/drawing/2014/main" id="{7FE8156B-447F-8B41-95D9-C65C3D251AE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08387" y="155416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" name="Line 82">
                <a:extLst>
                  <a:ext uri="{FF2B5EF4-FFF2-40B4-BE49-F238E27FC236}">
                    <a16:creationId xmlns:a16="http://schemas.microsoft.com/office/drawing/2014/main" id="{C74248B0-0A46-C54E-8F9E-8BEE585DBA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08387" y="232251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" name="Line 83">
                <a:extLst>
                  <a:ext uri="{FF2B5EF4-FFF2-40B4-BE49-F238E27FC236}">
                    <a16:creationId xmlns:a16="http://schemas.microsoft.com/office/drawing/2014/main" id="{037D10A1-1920-884D-9D8D-372988CB47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648075" y="1552576"/>
                <a:ext cx="0" cy="769938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" name="Line 84">
                <a:extLst>
                  <a:ext uri="{FF2B5EF4-FFF2-40B4-BE49-F238E27FC236}">
                    <a16:creationId xmlns:a16="http://schemas.microsoft.com/office/drawing/2014/main" id="{4EFEA214-8200-D24D-81EA-099B4C15BD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41737" y="1606551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9" name="Line 85">
                <a:extLst>
                  <a:ext uri="{FF2B5EF4-FFF2-40B4-BE49-F238E27FC236}">
                    <a16:creationId xmlns:a16="http://schemas.microsoft.com/office/drawing/2014/main" id="{0C5AE88A-7556-9348-89B3-B04E8C4583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41737" y="2465388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0" name="Line 86">
                <a:extLst>
                  <a:ext uri="{FF2B5EF4-FFF2-40B4-BE49-F238E27FC236}">
                    <a16:creationId xmlns:a16="http://schemas.microsoft.com/office/drawing/2014/main" id="{A4C818D3-8501-B54B-8E96-87C122D069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1425" y="1604963"/>
                <a:ext cx="0" cy="860425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1" name="Line 87">
                <a:extLst>
                  <a:ext uri="{FF2B5EF4-FFF2-40B4-BE49-F238E27FC236}">
                    <a16:creationId xmlns:a16="http://schemas.microsoft.com/office/drawing/2014/main" id="{B3DDE33C-E74B-4F43-92AD-02643F91CF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76675" y="140017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2" name="Line 88">
                <a:extLst>
                  <a:ext uri="{FF2B5EF4-FFF2-40B4-BE49-F238E27FC236}">
                    <a16:creationId xmlns:a16="http://schemas.microsoft.com/office/drawing/2014/main" id="{2F118CC1-FA2B-AB48-989E-57F3E9C0A2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76675" y="243681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3" name="Line 89">
                <a:extLst>
                  <a:ext uri="{FF2B5EF4-FFF2-40B4-BE49-F238E27FC236}">
                    <a16:creationId xmlns:a16="http://schemas.microsoft.com/office/drawing/2014/main" id="{C8FB856E-E3C2-334D-9BE7-9283FB0BB8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16362" y="1397001"/>
                <a:ext cx="0" cy="1039813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4" name="Line 90">
                <a:extLst>
                  <a:ext uri="{FF2B5EF4-FFF2-40B4-BE49-F238E27FC236}">
                    <a16:creationId xmlns:a16="http://schemas.microsoft.com/office/drawing/2014/main" id="{03A1CA81-F774-494C-90F4-D75C80BBB3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59450" y="2024063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5" name="Line 91">
                <a:extLst>
                  <a:ext uri="{FF2B5EF4-FFF2-40B4-BE49-F238E27FC236}">
                    <a16:creationId xmlns:a16="http://schemas.microsoft.com/office/drawing/2014/main" id="{4B90A6C8-FE95-2245-8741-3D875D184D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59450" y="2524126"/>
                <a:ext cx="79375" cy="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6" name="Line 92">
                <a:extLst>
                  <a:ext uri="{FF2B5EF4-FFF2-40B4-BE49-F238E27FC236}">
                    <a16:creationId xmlns:a16="http://schemas.microsoft.com/office/drawing/2014/main" id="{62F4C107-D1A1-A246-9C69-2AD7263D85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799137" y="2022476"/>
                <a:ext cx="0" cy="501650"/>
              </a:xfrm>
              <a:prstGeom prst="line">
                <a:avLst/>
              </a:prstGeom>
              <a:noFill/>
              <a:ln w="9525" cap="flat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37" name="Group 336">
            <a:extLst>
              <a:ext uri="{FF2B5EF4-FFF2-40B4-BE49-F238E27FC236}">
                <a16:creationId xmlns:a16="http://schemas.microsoft.com/office/drawing/2014/main" id="{3529153D-4EE3-3D4F-86AD-044353A99419}"/>
              </a:ext>
            </a:extLst>
          </p:cNvPr>
          <p:cNvGrpSpPr/>
          <p:nvPr/>
        </p:nvGrpSpPr>
        <p:grpSpPr>
          <a:xfrm>
            <a:off x="2773801" y="2271242"/>
            <a:ext cx="5849938" cy="987424"/>
            <a:chOff x="6202363" y="2214563"/>
            <a:chExt cx="5849938" cy="987424"/>
          </a:xfrm>
          <a:solidFill>
            <a:schemeClr val="tx1"/>
          </a:solidFill>
        </p:grpSpPr>
        <p:sp>
          <p:nvSpPr>
            <p:cNvPr id="338" name="Oval 97">
              <a:extLst>
                <a:ext uri="{FF2B5EF4-FFF2-40B4-BE49-F238E27FC236}">
                  <a16:creationId xmlns:a16="http://schemas.microsoft.com/office/drawing/2014/main" id="{F3255AA0-B425-564D-A8FD-76DF1A4A3F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02363" y="2838450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9" name="Oval 98">
              <a:extLst>
                <a:ext uri="{FF2B5EF4-FFF2-40B4-BE49-F238E27FC236}">
                  <a16:creationId xmlns:a16="http://schemas.microsoft.com/office/drawing/2014/main" id="{0446BA87-BC72-EA45-B28B-BA853C99B5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35713" y="2870200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0" name="Oval 99">
              <a:extLst>
                <a:ext uri="{FF2B5EF4-FFF2-40B4-BE49-F238E27FC236}">
                  <a16:creationId xmlns:a16="http://schemas.microsoft.com/office/drawing/2014/main" id="{37FE279A-454B-8D4A-BFE1-207879EA3A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70650" y="2708275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Oval 100">
              <a:extLst>
                <a:ext uri="{FF2B5EF4-FFF2-40B4-BE49-F238E27FC236}">
                  <a16:creationId xmlns:a16="http://schemas.microsoft.com/office/drawing/2014/main" id="{C5399E78-1330-154B-9EFD-5F93F5F8FF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04000" y="2698750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" name="Oval 101">
              <a:extLst>
                <a:ext uri="{FF2B5EF4-FFF2-40B4-BE49-F238E27FC236}">
                  <a16:creationId xmlns:a16="http://schemas.microsoft.com/office/drawing/2014/main" id="{17A061CE-85C0-1942-B7FE-2A904C936F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738938" y="2670175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3" name="Oval 102">
              <a:extLst>
                <a:ext uri="{FF2B5EF4-FFF2-40B4-BE49-F238E27FC236}">
                  <a16:creationId xmlns:a16="http://schemas.microsoft.com/office/drawing/2014/main" id="{1615F7B5-0BB1-4242-B4CB-89B8A111C0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72288" y="2689225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Oval 103">
              <a:extLst>
                <a:ext uri="{FF2B5EF4-FFF2-40B4-BE49-F238E27FC236}">
                  <a16:creationId xmlns:a16="http://schemas.microsoft.com/office/drawing/2014/main" id="{DC97A6D1-73A8-A641-A2F4-98EDF4FECA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07225" y="2573338"/>
              <a:ext cx="73025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Oval 104">
              <a:extLst>
                <a:ext uri="{FF2B5EF4-FFF2-40B4-BE49-F238E27FC236}">
                  <a16:creationId xmlns:a16="http://schemas.microsoft.com/office/drawing/2014/main" id="{F7E77443-91EA-4A45-A6F4-BB2E00E3A4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38988" y="2586038"/>
              <a:ext cx="73025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Oval 105">
              <a:extLst>
                <a:ext uri="{FF2B5EF4-FFF2-40B4-BE49-F238E27FC236}">
                  <a16:creationId xmlns:a16="http://schemas.microsoft.com/office/drawing/2014/main" id="{47CB9EFF-D7B9-5A40-BB10-2F92DAF22F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77100" y="2709863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Oval 106">
              <a:extLst>
                <a:ext uri="{FF2B5EF4-FFF2-40B4-BE49-F238E27FC236}">
                  <a16:creationId xmlns:a16="http://schemas.microsoft.com/office/drawing/2014/main" id="{546949B9-A0BF-214C-B958-8530DEF540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08863" y="2681288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" name="Oval 107">
              <a:extLst>
                <a:ext uri="{FF2B5EF4-FFF2-40B4-BE49-F238E27FC236}">
                  <a16:creationId xmlns:a16="http://schemas.microsoft.com/office/drawing/2014/main" id="{99F31BD0-99D2-CC44-BB48-1C74D308BD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45388" y="2598738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9" name="Oval 108">
              <a:extLst>
                <a:ext uri="{FF2B5EF4-FFF2-40B4-BE49-F238E27FC236}">
                  <a16:creationId xmlns:a16="http://schemas.microsoft.com/office/drawing/2014/main" id="{94A6F0D4-9EBC-4E4E-BDB5-A77B88B03C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81913" y="2646363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" name="Oval 109">
              <a:extLst>
                <a:ext uri="{FF2B5EF4-FFF2-40B4-BE49-F238E27FC236}">
                  <a16:creationId xmlns:a16="http://schemas.microsoft.com/office/drawing/2014/main" id="{7C3B6996-3039-2E48-B4BA-57BD4806B6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12088" y="2668588"/>
              <a:ext cx="73025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" name="Oval 110">
              <a:extLst>
                <a:ext uri="{FF2B5EF4-FFF2-40B4-BE49-F238E27FC236}">
                  <a16:creationId xmlns:a16="http://schemas.microsoft.com/office/drawing/2014/main" id="{383B2730-F62C-2342-B24C-6C2A9AC790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47025" y="2636838"/>
              <a:ext cx="73025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" name="Oval 111">
              <a:extLst>
                <a:ext uri="{FF2B5EF4-FFF2-40B4-BE49-F238E27FC236}">
                  <a16:creationId xmlns:a16="http://schemas.microsoft.com/office/drawing/2014/main" id="{18AA1D49-E2EF-3648-A943-D3D304183C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81963" y="2786063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3" name="Oval 112">
              <a:extLst>
                <a:ext uri="{FF2B5EF4-FFF2-40B4-BE49-F238E27FC236}">
                  <a16:creationId xmlns:a16="http://schemas.microsoft.com/office/drawing/2014/main" id="{08FC7548-7BE9-DC4B-A2D3-EDA996FA1D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18488" y="2709863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" name="Oval 113">
              <a:extLst>
                <a:ext uri="{FF2B5EF4-FFF2-40B4-BE49-F238E27FC236}">
                  <a16:creationId xmlns:a16="http://schemas.microsoft.com/office/drawing/2014/main" id="{3F1B179E-EC7D-E04E-BBE5-1B0C76259C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51838" y="2617788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" name="Oval 114">
              <a:extLst>
                <a:ext uri="{FF2B5EF4-FFF2-40B4-BE49-F238E27FC236}">
                  <a16:creationId xmlns:a16="http://schemas.microsoft.com/office/drawing/2014/main" id="{D475B733-7BAA-634D-84CE-D05B9FEE9F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85188" y="2608263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" name="Oval 115">
              <a:extLst>
                <a:ext uri="{FF2B5EF4-FFF2-40B4-BE49-F238E27FC236}">
                  <a16:creationId xmlns:a16="http://schemas.microsoft.com/office/drawing/2014/main" id="{A09BB55D-556D-A44D-8284-44631F5467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21713" y="2827338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" name="Oval 116">
              <a:extLst>
                <a:ext uri="{FF2B5EF4-FFF2-40B4-BE49-F238E27FC236}">
                  <a16:creationId xmlns:a16="http://schemas.microsoft.com/office/drawing/2014/main" id="{E588AC1B-EEC8-5E47-B6AA-791EB3C1B1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56650" y="2786063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" name="Oval 117">
              <a:extLst>
                <a:ext uri="{FF2B5EF4-FFF2-40B4-BE49-F238E27FC236}">
                  <a16:creationId xmlns:a16="http://schemas.microsoft.com/office/drawing/2014/main" id="{E18DDC57-C99A-F646-93E5-176827B6D8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888413" y="2746375"/>
              <a:ext cx="73025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9" name="Oval 118">
              <a:extLst>
                <a:ext uri="{FF2B5EF4-FFF2-40B4-BE49-F238E27FC236}">
                  <a16:creationId xmlns:a16="http://schemas.microsoft.com/office/drawing/2014/main" id="{9F66EFE4-C198-3D4C-A2A1-A415DC9BCF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23350" y="2738438"/>
              <a:ext cx="73025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" name="Oval 119">
              <a:extLst>
                <a:ext uri="{FF2B5EF4-FFF2-40B4-BE49-F238E27FC236}">
                  <a16:creationId xmlns:a16="http://schemas.microsoft.com/office/drawing/2014/main" id="{AD826CB4-23D2-344F-85D8-F04C86EE31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56700" y="2824163"/>
              <a:ext cx="73025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Oval 120">
              <a:extLst>
                <a:ext uri="{FF2B5EF4-FFF2-40B4-BE49-F238E27FC236}">
                  <a16:creationId xmlns:a16="http://schemas.microsoft.com/office/drawing/2014/main" id="{476D2778-DE25-354F-AA59-6854800BB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293225" y="2747963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2" name="Oval 121">
              <a:extLst>
                <a:ext uri="{FF2B5EF4-FFF2-40B4-BE49-F238E27FC236}">
                  <a16:creationId xmlns:a16="http://schemas.microsoft.com/office/drawing/2014/main" id="{08A2B985-6391-554B-9DA3-7F977E75D9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426575" y="2671763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3" name="Oval 122">
              <a:extLst>
                <a:ext uri="{FF2B5EF4-FFF2-40B4-BE49-F238E27FC236}">
                  <a16:creationId xmlns:a16="http://schemas.microsoft.com/office/drawing/2014/main" id="{EA4BF7CE-9854-AE42-807B-EACA6881D9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61513" y="2541588"/>
              <a:ext cx="73025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4" name="Oval 123">
              <a:extLst>
                <a:ext uri="{FF2B5EF4-FFF2-40B4-BE49-F238E27FC236}">
                  <a16:creationId xmlns:a16="http://schemas.microsoft.com/office/drawing/2014/main" id="{D6516406-19BE-C04D-A864-9CB6C31E24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694863" y="2636838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5" name="Oval 124">
              <a:extLst>
                <a:ext uri="{FF2B5EF4-FFF2-40B4-BE49-F238E27FC236}">
                  <a16:creationId xmlns:a16="http://schemas.microsoft.com/office/drawing/2014/main" id="{44CF0059-8C65-9A4D-945E-15A5EFCEDA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29800" y="2522538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6" name="Oval 125">
              <a:extLst>
                <a:ext uri="{FF2B5EF4-FFF2-40B4-BE49-F238E27FC236}">
                  <a16:creationId xmlns:a16="http://schemas.microsoft.com/office/drawing/2014/main" id="{1D79E060-2B6F-5D42-B355-899B08790D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63150" y="2959100"/>
              <a:ext cx="73025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7" name="Oval 126">
              <a:extLst>
                <a:ext uri="{FF2B5EF4-FFF2-40B4-BE49-F238E27FC236}">
                  <a16:creationId xmlns:a16="http://schemas.microsoft.com/office/drawing/2014/main" id="{655A0228-29E5-F54F-9B06-515065F67C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33025" y="2905125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" name="Oval 127">
              <a:extLst>
                <a:ext uri="{FF2B5EF4-FFF2-40B4-BE49-F238E27FC236}">
                  <a16:creationId xmlns:a16="http://schemas.microsoft.com/office/drawing/2014/main" id="{8EDD7244-5E14-3042-934C-105EFE0992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099675" y="2597150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" name="Oval 128">
              <a:extLst>
                <a:ext uri="{FF2B5EF4-FFF2-40B4-BE49-F238E27FC236}">
                  <a16:creationId xmlns:a16="http://schemas.microsoft.com/office/drawing/2014/main" id="{EF1917D3-68BD-8145-BE6C-CAC1040C95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367963" y="2697453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0" name="Oval 129">
              <a:extLst>
                <a:ext uri="{FF2B5EF4-FFF2-40B4-BE49-F238E27FC236}">
                  <a16:creationId xmlns:a16="http://schemas.microsoft.com/office/drawing/2014/main" id="{812A2A80-9AF9-2E42-92C7-9ED4CAE39E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04488" y="2671763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1" name="Oval 130">
              <a:extLst>
                <a:ext uri="{FF2B5EF4-FFF2-40B4-BE49-F238E27FC236}">
                  <a16:creationId xmlns:a16="http://schemas.microsoft.com/office/drawing/2014/main" id="{EC93F37F-3144-E742-B477-DE7D42C9DC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772775" y="2676525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2" name="Oval 131">
              <a:extLst>
                <a:ext uri="{FF2B5EF4-FFF2-40B4-BE49-F238E27FC236}">
                  <a16:creationId xmlns:a16="http://schemas.microsoft.com/office/drawing/2014/main" id="{8A8CB9F6-1C4A-944E-A6A3-0F9B8AD51C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637838" y="2444750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3" name="Oval 132">
              <a:extLst>
                <a:ext uri="{FF2B5EF4-FFF2-40B4-BE49-F238E27FC236}">
                  <a16:creationId xmlns:a16="http://schemas.microsoft.com/office/drawing/2014/main" id="{AC33AC09-5DDB-D84A-8A13-D07870C1E0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04538" y="2216150"/>
              <a:ext cx="71438" cy="73025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4" name="Oval 133">
              <a:extLst>
                <a:ext uri="{FF2B5EF4-FFF2-40B4-BE49-F238E27FC236}">
                  <a16:creationId xmlns:a16="http://schemas.microsoft.com/office/drawing/2014/main" id="{D58FEAE7-2638-7B4C-ABED-D4177D3C1C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39475" y="2217738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5" name="Oval 134">
              <a:extLst>
                <a:ext uri="{FF2B5EF4-FFF2-40B4-BE49-F238E27FC236}">
                  <a16:creationId xmlns:a16="http://schemas.microsoft.com/office/drawing/2014/main" id="{21AEB7A6-1688-D047-B771-78726B3890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09350" y="2214563"/>
              <a:ext cx="73025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6" name="Oval 135">
              <a:extLst>
                <a:ext uri="{FF2B5EF4-FFF2-40B4-BE49-F238E27FC236}">
                  <a16:creationId xmlns:a16="http://schemas.microsoft.com/office/drawing/2014/main" id="{6B570FED-0367-E645-ADB6-707BA03A60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172825" y="2668588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7" name="Oval 136">
              <a:extLst>
                <a:ext uri="{FF2B5EF4-FFF2-40B4-BE49-F238E27FC236}">
                  <a16:creationId xmlns:a16="http://schemas.microsoft.com/office/drawing/2014/main" id="{BABFC4E7-B98F-6A45-800D-EB7EE3F9A9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712575" y="2878138"/>
              <a:ext cx="73025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Oval 137">
              <a:extLst>
                <a:ext uri="{FF2B5EF4-FFF2-40B4-BE49-F238E27FC236}">
                  <a16:creationId xmlns:a16="http://schemas.microsoft.com/office/drawing/2014/main" id="{304EE2E7-6A8B-B14F-85D1-D7B52EF03D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42700" y="3127375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9" name="Oval 138">
              <a:extLst>
                <a:ext uri="{FF2B5EF4-FFF2-40B4-BE49-F238E27FC236}">
                  <a16:creationId xmlns:a16="http://schemas.microsoft.com/office/drawing/2014/main" id="{C5869612-4790-A543-BCF3-3F843ABFD2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80863" y="3130550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Oval 139">
              <a:extLst>
                <a:ext uri="{FF2B5EF4-FFF2-40B4-BE49-F238E27FC236}">
                  <a16:creationId xmlns:a16="http://schemas.microsoft.com/office/drawing/2014/main" id="{AD52720C-53F8-2B46-BF31-BECBDB96B3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47513" y="2673350"/>
              <a:ext cx="71438" cy="71437"/>
            </a:xfrm>
            <a:prstGeom prst="ellipse">
              <a:avLst/>
            </a:prstGeom>
            <a:grpFill/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1" name="Group 380">
            <a:extLst>
              <a:ext uri="{FF2B5EF4-FFF2-40B4-BE49-F238E27FC236}">
                <a16:creationId xmlns:a16="http://schemas.microsoft.com/office/drawing/2014/main" id="{7749D0A0-BD35-7C4E-84AA-830067CD6C02}"/>
              </a:ext>
            </a:extLst>
          </p:cNvPr>
          <p:cNvGrpSpPr/>
          <p:nvPr/>
        </p:nvGrpSpPr>
        <p:grpSpPr>
          <a:xfrm>
            <a:off x="4430712" y="4194237"/>
            <a:ext cx="2564590" cy="230832"/>
            <a:chOff x="4738530" y="5810080"/>
            <a:chExt cx="2564590" cy="230832"/>
          </a:xfrm>
        </p:grpSpPr>
        <p:grpSp>
          <p:nvGrpSpPr>
            <p:cNvPr id="382" name="Group 381">
              <a:extLst>
                <a:ext uri="{FF2B5EF4-FFF2-40B4-BE49-F238E27FC236}">
                  <a16:creationId xmlns:a16="http://schemas.microsoft.com/office/drawing/2014/main" id="{8531472C-F1A6-F94B-98EF-77CFA8A67986}"/>
                </a:ext>
              </a:extLst>
            </p:cNvPr>
            <p:cNvGrpSpPr/>
            <p:nvPr/>
          </p:nvGrpSpPr>
          <p:grpSpPr>
            <a:xfrm>
              <a:off x="6456981" y="5810080"/>
              <a:ext cx="846139" cy="230832"/>
              <a:chOff x="6456981" y="5810080"/>
              <a:chExt cx="846139" cy="230832"/>
            </a:xfrm>
          </p:grpSpPr>
          <p:sp>
            <p:nvSpPr>
              <p:cNvPr id="388" name="TextBox 387">
                <a:extLst>
                  <a:ext uri="{FF2B5EF4-FFF2-40B4-BE49-F238E27FC236}">
                    <a16:creationId xmlns:a16="http://schemas.microsoft.com/office/drawing/2014/main" id="{80CEA644-0F73-3447-9D09-B975B1936151}"/>
                  </a:ext>
                </a:extLst>
              </p:cNvPr>
              <p:cNvSpPr txBox="1"/>
              <p:nvPr/>
            </p:nvSpPr>
            <p:spPr>
              <a:xfrm>
                <a:off x="6557824" y="5810080"/>
                <a:ext cx="74529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RO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zacitidine</a:t>
                </a:r>
              </a:p>
            </p:txBody>
          </p:sp>
          <p:grpSp>
            <p:nvGrpSpPr>
              <p:cNvPr id="389" name="Group 388">
                <a:extLst>
                  <a:ext uri="{FF2B5EF4-FFF2-40B4-BE49-F238E27FC236}">
                    <a16:creationId xmlns:a16="http://schemas.microsoft.com/office/drawing/2014/main" id="{1B9D39A3-42BD-964F-9686-3371DFB95BE2}"/>
                  </a:ext>
                </a:extLst>
              </p:cNvPr>
              <p:cNvGrpSpPr/>
              <p:nvPr/>
            </p:nvGrpSpPr>
            <p:grpSpPr>
              <a:xfrm>
                <a:off x="6456981" y="5889778"/>
                <a:ext cx="144463" cy="71437"/>
                <a:chOff x="6358556" y="5705545"/>
                <a:chExt cx="144463" cy="71437"/>
              </a:xfrm>
            </p:grpSpPr>
            <p:sp>
              <p:nvSpPr>
                <p:cNvPr id="390" name="Line 93">
                  <a:extLst>
                    <a:ext uri="{FF2B5EF4-FFF2-40B4-BE49-F238E27FC236}">
                      <a16:creationId xmlns:a16="http://schemas.microsoft.com/office/drawing/2014/main" id="{9E9AA3BC-CF87-914F-9D9F-BDFD8584823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358556" y="5739987"/>
                  <a:ext cx="144463" cy="0"/>
                </a:xfrm>
                <a:prstGeom prst="line">
                  <a:avLst/>
                </a:prstGeom>
                <a:noFill/>
                <a:ln w="19050" cap="flat">
                  <a:solidFill>
                    <a:schemeClr val="tx1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1" name="Oval 140">
                  <a:extLst>
                    <a:ext uri="{FF2B5EF4-FFF2-40B4-BE49-F238E27FC236}">
                      <a16:creationId xmlns:a16="http://schemas.microsoft.com/office/drawing/2014/main" id="{25C12EC9-C0B3-8D49-ADDF-DB027EC1D72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393758" y="5705545"/>
                  <a:ext cx="73025" cy="71437"/>
                </a:xfrm>
                <a:prstGeom prst="ellipse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383" name="Group 382">
              <a:extLst>
                <a:ext uri="{FF2B5EF4-FFF2-40B4-BE49-F238E27FC236}">
                  <a16:creationId xmlns:a16="http://schemas.microsoft.com/office/drawing/2014/main" id="{4888027A-AFC9-A147-A780-7B512DD335CF}"/>
                </a:ext>
              </a:extLst>
            </p:cNvPr>
            <p:cNvGrpSpPr/>
            <p:nvPr/>
          </p:nvGrpSpPr>
          <p:grpSpPr>
            <a:xfrm>
              <a:off x="4738530" y="5810080"/>
              <a:ext cx="1763870" cy="230832"/>
              <a:chOff x="4738530" y="5810080"/>
              <a:chExt cx="1763870" cy="230832"/>
            </a:xfrm>
          </p:grpSpPr>
          <p:sp>
            <p:nvSpPr>
              <p:cNvPr id="384" name="TextBox 383">
                <a:extLst>
                  <a:ext uri="{FF2B5EF4-FFF2-40B4-BE49-F238E27FC236}">
                    <a16:creationId xmlns:a16="http://schemas.microsoft.com/office/drawing/2014/main" id="{13A907DC-79B6-FD4B-AF25-1D8620E807B1}"/>
                  </a:ext>
                </a:extLst>
              </p:cNvPr>
              <p:cNvSpPr txBox="1"/>
              <p:nvPr/>
            </p:nvSpPr>
            <p:spPr>
              <a:xfrm>
                <a:off x="4850532" y="5810080"/>
                <a:ext cx="165186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Pevonedistat + azacitidine</a:t>
                </a:r>
                <a:endParaRPr lang="en-RO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85" name="Group 384">
                <a:extLst>
                  <a:ext uri="{FF2B5EF4-FFF2-40B4-BE49-F238E27FC236}">
                    <a16:creationId xmlns:a16="http://schemas.microsoft.com/office/drawing/2014/main" id="{158EE605-1E3B-F747-9857-DED2DBA36850}"/>
                  </a:ext>
                </a:extLst>
              </p:cNvPr>
              <p:cNvGrpSpPr/>
              <p:nvPr/>
            </p:nvGrpSpPr>
            <p:grpSpPr>
              <a:xfrm>
                <a:off x="4738530" y="5888984"/>
                <a:ext cx="144463" cy="73025"/>
                <a:chOff x="4484530" y="5703957"/>
                <a:chExt cx="144463" cy="73025"/>
              </a:xfrm>
            </p:grpSpPr>
            <p:sp>
              <p:nvSpPr>
                <p:cNvPr id="386" name="Line 102">
                  <a:extLst>
                    <a:ext uri="{FF2B5EF4-FFF2-40B4-BE49-F238E27FC236}">
                      <a16:creationId xmlns:a16="http://schemas.microsoft.com/office/drawing/2014/main" id="{104EBB0E-EF1F-EC43-8ED3-131FDCCE937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84530" y="5740875"/>
                  <a:ext cx="144463" cy="0"/>
                </a:xfrm>
                <a:prstGeom prst="line">
                  <a:avLst/>
                </a:prstGeom>
                <a:noFill/>
                <a:ln w="19050" cap="flat">
                  <a:solidFill>
                    <a:srgbClr val="E60004"/>
                  </a:solidFill>
                  <a:prstDash val="solid"/>
                  <a:miter lim="800000"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7" name="Oval 41">
                  <a:extLst>
                    <a:ext uri="{FF2B5EF4-FFF2-40B4-BE49-F238E27FC236}">
                      <a16:creationId xmlns:a16="http://schemas.microsoft.com/office/drawing/2014/main" id="{F75F0229-68AA-A845-AD7F-8D922776BC8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519405" y="5703957"/>
                  <a:ext cx="73025" cy="73025"/>
                </a:xfrm>
                <a:prstGeom prst="ellipse">
                  <a:avLst/>
                </a:prstGeom>
                <a:solidFill>
                  <a:srgbClr val="E60004"/>
                </a:solidFill>
                <a:ln>
                  <a:noFill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392" name="TextBox 391">
            <a:extLst>
              <a:ext uri="{FF2B5EF4-FFF2-40B4-BE49-F238E27FC236}">
                <a16:creationId xmlns:a16="http://schemas.microsoft.com/office/drawing/2014/main" id="{5A956FAE-F4E4-514A-893D-71EBDB6BD0EF}"/>
              </a:ext>
            </a:extLst>
          </p:cNvPr>
          <p:cNvSpPr txBox="1"/>
          <p:nvPr/>
        </p:nvSpPr>
        <p:spPr>
          <a:xfrm>
            <a:off x="2800098" y="5007228"/>
            <a:ext cx="57911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RO" sz="900" b="1" dirty="0">
                <a:latin typeface="Arial" panose="020B0604020202020204" pitchFamily="34" charset="0"/>
                <a:cs typeface="Arial" panose="020B0604020202020204" pitchFamily="34" charset="0"/>
              </a:rPr>
              <a:t>Visit</a:t>
            </a:r>
          </a:p>
        </p:txBody>
      </p:sp>
      <p:sp>
        <p:nvSpPr>
          <p:cNvPr id="393" name="Oval 137">
            <a:extLst>
              <a:ext uri="{FF2B5EF4-FFF2-40B4-BE49-F238E27FC236}">
                <a16:creationId xmlns:a16="http://schemas.microsoft.com/office/drawing/2014/main" id="{304EE2E7-6A8B-B14F-85D1-D7B52EF03D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44829" y="3644740"/>
            <a:ext cx="71438" cy="71437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01644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2</Words>
  <Application>Microsoft Office PowerPoint</Application>
  <PresentationFormat>Widescreen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DG Healthca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Royce</dc:creator>
  <cp:lastModifiedBy>FireKite</cp:lastModifiedBy>
  <cp:revision>5</cp:revision>
  <dcterms:created xsi:type="dcterms:W3CDTF">2020-06-03T10:41:21Z</dcterms:created>
  <dcterms:modified xsi:type="dcterms:W3CDTF">2020-08-25T14:01:42Z</dcterms:modified>
</cp:coreProperties>
</file>